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notesSlides/notesSlide1.xml" ContentType="application/vnd.openxmlformats-officedocument.presentationml.notesSlide+xml"/>
  <Override PartName="/ppt/charts/chart15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16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17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18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19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20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21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22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23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24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313" r:id="rId2"/>
    <p:sldId id="277" r:id="rId3"/>
    <p:sldId id="328" r:id="rId4"/>
    <p:sldId id="331" r:id="rId5"/>
    <p:sldId id="329" r:id="rId6"/>
    <p:sldId id="330" r:id="rId7"/>
    <p:sldId id="279" r:id="rId8"/>
    <p:sldId id="261" r:id="rId9"/>
    <p:sldId id="272" r:id="rId10"/>
    <p:sldId id="294" r:id="rId11"/>
    <p:sldId id="295" r:id="rId12"/>
    <p:sldId id="260" r:id="rId13"/>
    <p:sldId id="311" r:id="rId14"/>
    <p:sldId id="280" r:id="rId15"/>
    <p:sldId id="282" r:id="rId16"/>
    <p:sldId id="283" r:id="rId17"/>
    <p:sldId id="284" r:id="rId18"/>
    <p:sldId id="286" r:id="rId1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508" autoAdjust="0"/>
    <p:restoredTop sz="87541"/>
  </p:normalViewPr>
  <p:slideViewPr>
    <p:cSldViewPr snapToGrid="0">
      <p:cViewPr varScale="1">
        <p:scale>
          <a:sx n="88" d="100"/>
          <a:sy n="88" d="100"/>
        </p:scale>
        <p:origin x="120" y="4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90" d="100"/>
        <a:sy n="90" d="100"/>
      </p:scale>
      <p:origin x="0" y="-166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jana:Desktop:AB-SO-67.xls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tachibana\Desktop\KT%20%2320%20data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tachibana\Desktop\KT%20%2320%20data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abhardwaj\Desktop\DeskTop%20Files\miR-29-2\AB-backup-11-06-15\AB-142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abhardwaj\Desktop\DeskTop%20Files\miR-29-2\AB-backup-11-06-15\AB-142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abhardwaj\Desktop\DeskTop%20Files\miR-29-2\AB-backup-11-06-15\AB-142.xlsx" TargetMode="Externa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hardwaj\Desktop\AB%23209%20-%20calc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hardwaj\Desktop\AB%23209%20-%20calc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hardwaj\Desktop\AB%23209%20-%20calc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hardwaj\Desktop\AB%23209%20-%20calc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hardwaj\Desktop\AB%23209%20-%20calc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njana:Desktop:AB-SO-67.xls" TargetMode="Externa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hardwaj\Desktop\AB%23209%20-%20calc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2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hardwaj\Desktop\AB%23209%20-%20calc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hardwaj\Desktop\AB%23209%20-%20calc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hardwaj\Desktop\AB%23209%20-%20calc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abhardwaj\Desktop\AB%23209%20-%20calc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abhardwaj:Desktop:AB-150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surg37\Anjana\IB%20-Lab\IB-data\Experiments\QPCR\AB-272%20-%20%20Quantification%20Cq%20Results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surg37\M.%20Embury\Odyssey\Quantification\MDE-67%20HS%20DICER%20and%20SCR-1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mymdafiles\surg37\DOS\Surg-Onc\Bedrosian%20Lab\K.%20Tachibana\qPCR\KT%20%2310-%20%20data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mymdafiles\surg37\DOS\Surg-Onc\Bedrosian%20Lab\K.%20Tachibana\qPCR\KT%20%2310-%20%20data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mymdafiles\surg37\DOS\Surg-Onc\Bedrosian%20Lab\K.%20Tachibana\qPCR\KT%20%2310-%20%20data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mymdafiles\surg37\DOS\Surg-Onc\Bedrosian%20Lab\K.%20Tachibana\qPCR\KT%20%2310-%20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miR-34a</a:t>
            </a:r>
          </a:p>
        </c:rich>
      </c:tx>
      <c:layout>
        <c:manualLayout>
          <c:xMode val="edge"/>
          <c:yMode val="edge"/>
          <c:x val="0.79553143240810942"/>
          <c:y val="3.6803891085465161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8.7316402900132498E-2"/>
          <c:y val="2.2140221402214E-2"/>
          <c:w val="0.90279440457111004"/>
          <c:h val="0.836120401337792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P$3:$P$7</c:f>
                <c:numCache>
                  <c:formatCode>General</c:formatCode>
                  <c:ptCount val="5"/>
                  <c:pt idx="0">
                    <c:v>6.9861431870669705E-2</c:v>
                  </c:pt>
                  <c:pt idx="1">
                    <c:v>0.194572748267898</c:v>
                  </c:pt>
                  <c:pt idx="2">
                    <c:v>0.52251732101616599</c:v>
                  </c:pt>
                  <c:pt idx="3">
                    <c:v>0.184757505773672</c:v>
                  </c:pt>
                  <c:pt idx="4">
                    <c:v>9.1224018475750596E-2</c:v>
                  </c:pt>
                </c:numCache>
              </c:numRef>
            </c:plus>
            <c:minus>
              <c:numRef>
                <c:f>Sheet1!$P$3:$P$7</c:f>
                <c:numCache>
                  <c:formatCode>General</c:formatCode>
                  <c:ptCount val="5"/>
                  <c:pt idx="0">
                    <c:v>6.9861431870669705E-2</c:v>
                  </c:pt>
                  <c:pt idx="1">
                    <c:v>0.194572748267898</c:v>
                  </c:pt>
                  <c:pt idx="2">
                    <c:v>0.52251732101616599</c:v>
                  </c:pt>
                  <c:pt idx="3">
                    <c:v>0.184757505773672</c:v>
                  </c:pt>
                  <c:pt idx="4">
                    <c:v>9.1224018475750596E-2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J$3:$J$7</c:f>
              <c:strCache>
                <c:ptCount val="5"/>
                <c:pt idx="0">
                  <c:v>MCF10A (P)</c:v>
                </c:pt>
                <c:pt idx="1">
                  <c:v>MCF10A neoT1</c:v>
                </c:pt>
                <c:pt idx="2">
                  <c:v>MCF10A AT1</c:v>
                </c:pt>
                <c:pt idx="3">
                  <c:v>MCF10A Ca1d</c:v>
                </c:pt>
                <c:pt idx="4">
                  <c:v>MCF10A ca1h</c:v>
                </c:pt>
              </c:strCache>
            </c:strRef>
          </c:cat>
          <c:val>
            <c:numRef>
              <c:f>Sheet1!$O$3:$O$7</c:f>
              <c:numCache>
                <c:formatCode>0.00</c:formatCode>
                <c:ptCount val="5"/>
                <c:pt idx="0">
                  <c:v>1</c:v>
                </c:pt>
                <c:pt idx="1">
                  <c:v>3.7269999999999999</c:v>
                </c:pt>
                <c:pt idx="2">
                  <c:v>1.91</c:v>
                </c:pt>
                <c:pt idx="3">
                  <c:v>3.2839999999999998</c:v>
                </c:pt>
                <c:pt idx="4">
                  <c:v>2.64699999999999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4B06-0F4B-BA57-D720FEE3BF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5618672"/>
        <c:axId val="445619232"/>
      </c:barChart>
      <c:catAx>
        <c:axId val="4456186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445619232"/>
        <c:crosses val="autoZero"/>
        <c:auto val="1"/>
        <c:lblAlgn val="ctr"/>
        <c:lblOffset val="100"/>
        <c:noMultiLvlLbl val="0"/>
      </c:catAx>
      <c:valAx>
        <c:axId val="445619232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445618672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>
        <c:manualLayout>
          <c:xMode val="edge"/>
          <c:yMode val="edge"/>
          <c:x val="0.14098309886996299"/>
          <c:y val="0.165680473372781"/>
        </c:manualLayout>
      </c:layout>
      <c:overlay val="0"/>
      <c:txPr>
        <a:bodyPr/>
        <a:lstStyle/>
        <a:p>
          <a:pPr>
            <a:defRPr lang="ja-JP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1311237768919"/>
          <c:y val="7.0858221124726298E-2"/>
          <c:w val="0.84429545679175"/>
          <c:h val="0.761883240926245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I$69</c:f>
              <c:strCache>
                <c:ptCount val="1"/>
                <c:pt idx="0">
                  <c:v>MES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'!$AI$76:$AI$7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2962073477059397E-2</c:v>
                  </c:pt>
                  <c:pt idx="2">
                    <c:v>0.48182724514331599</c:v>
                  </c:pt>
                  <c:pt idx="3">
                    <c:v>5.9377416488683901E-2</c:v>
                  </c:pt>
                </c:numCache>
              </c:numRef>
            </c:plus>
            <c:minus>
              <c:numRef>
                <c:f>'0'!$AI$76:$AI$7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2962073477059397E-2</c:v>
                  </c:pt>
                  <c:pt idx="2">
                    <c:v>0.48182724514331599</c:v>
                  </c:pt>
                  <c:pt idx="3">
                    <c:v>5.9377416488683901E-2</c:v>
                  </c:pt>
                </c:numCache>
              </c:numRef>
            </c:minus>
          </c:errBars>
          <c:cat>
            <c:strRef>
              <c:f>'0'!$Y$70:$Y$73</c:f>
              <c:strCache>
                <c:ptCount val="4"/>
                <c:pt idx="0">
                  <c:v>10A</c:v>
                </c:pt>
                <c:pt idx="1">
                  <c:v>AT1</c:v>
                </c:pt>
                <c:pt idx="2">
                  <c:v>DCIS</c:v>
                </c:pt>
                <c:pt idx="3">
                  <c:v>Ca1d</c:v>
                </c:pt>
              </c:strCache>
            </c:strRef>
          </c:cat>
          <c:val>
            <c:numRef>
              <c:f>'0'!$AI$70:$AI$73</c:f>
              <c:numCache>
                <c:formatCode>General</c:formatCode>
                <c:ptCount val="4"/>
                <c:pt idx="0">
                  <c:v>1</c:v>
                </c:pt>
                <c:pt idx="1">
                  <c:v>1.6161355881802171</c:v>
                </c:pt>
                <c:pt idx="2">
                  <c:v>2.7158414284244641</c:v>
                </c:pt>
                <c:pt idx="3">
                  <c:v>1.82548389354422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D30-3940-968C-8FEC841501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9156880"/>
        <c:axId val="459157440"/>
      </c:barChart>
      <c:catAx>
        <c:axId val="4591568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 sz="1200">
                <a:latin typeface="+mn-lt"/>
              </a:defRPr>
            </a:pPr>
            <a:endParaRPr lang="en-US"/>
          </a:p>
        </c:txPr>
        <c:crossAx val="459157440"/>
        <c:crosses val="autoZero"/>
        <c:auto val="1"/>
        <c:lblAlgn val="ctr"/>
        <c:lblOffset val="100"/>
        <c:noMultiLvlLbl val="0"/>
      </c:catAx>
      <c:valAx>
        <c:axId val="45915744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 sz="1200">
                <a:latin typeface="+mn-lt"/>
              </a:defRPr>
            </a:pPr>
            <a:endParaRPr lang="en-US"/>
          </a:p>
        </c:txPr>
        <c:crossAx val="4591568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layout>
        <c:manualLayout>
          <c:xMode val="edge"/>
          <c:yMode val="edge"/>
          <c:x val="0.13711297071129699"/>
          <c:y val="0.13017751479289899"/>
        </c:manualLayout>
      </c:layout>
      <c:overlay val="0"/>
      <c:txPr>
        <a:bodyPr/>
        <a:lstStyle/>
        <a:p>
          <a:pPr>
            <a:defRPr lang="ja-JP"/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2943036932098905E-2"/>
          <c:y val="0.27795881284070301"/>
          <c:w val="0.84429545679175"/>
          <c:h val="0.554782649210268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M$69</c:f>
              <c:strCache>
                <c:ptCount val="1"/>
                <c:pt idx="0">
                  <c:v>ETV4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'!$AM$76:$AM$7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39267429969747</c:v>
                  </c:pt>
                  <c:pt idx="2">
                    <c:v>0.112759261154111</c:v>
                  </c:pt>
                  <c:pt idx="3">
                    <c:v>7.1649258468278895E-2</c:v>
                  </c:pt>
                </c:numCache>
              </c:numRef>
            </c:plus>
            <c:minus>
              <c:numRef>
                <c:f>'0'!$AM$76:$AM$7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39267429969747</c:v>
                  </c:pt>
                  <c:pt idx="2">
                    <c:v>0.112759261154111</c:v>
                  </c:pt>
                  <c:pt idx="3">
                    <c:v>7.1649258468278895E-2</c:v>
                  </c:pt>
                </c:numCache>
              </c:numRef>
            </c:minus>
          </c:errBars>
          <c:cat>
            <c:strRef>
              <c:f>'0'!$Y$70:$Y$73</c:f>
              <c:strCache>
                <c:ptCount val="4"/>
                <c:pt idx="0">
                  <c:v>10A</c:v>
                </c:pt>
                <c:pt idx="1">
                  <c:v>AT1</c:v>
                </c:pt>
                <c:pt idx="2">
                  <c:v>DCIS</c:v>
                </c:pt>
                <c:pt idx="3">
                  <c:v>Ca1d</c:v>
                </c:pt>
              </c:strCache>
            </c:strRef>
          </c:cat>
          <c:val>
            <c:numRef>
              <c:f>'0'!$AM$70:$AM$73</c:f>
              <c:numCache>
                <c:formatCode>General</c:formatCode>
                <c:ptCount val="4"/>
                <c:pt idx="0">
                  <c:v>1</c:v>
                </c:pt>
                <c:pt idx="1">
                  <c:v>4.8059182210400326</c:v>
                </c:pt>
                <c:pt idx="2">
                  <c:v>1.7337445183340601</c:v>
                </c:pt>
                <c:pt idx="3">
                  <c:v>6.39210020102613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944-964B-99C6-C8151C3503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9159680"/>
        <c:axId val="459160240"/>
      </c:barChart>
      <c:catAx>
        <c:axId val="4591596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 sz="1200">
                <a:latin typeface="+mn-lt"/>
              </a:defRPr>
            </a:pPr>
            <a:endParaRPr lang="en-US"/>
          </a:p>
        </c:txPr>
        <c:crossAx val="459160240"/>
        <c:crosses val="autoZero"/>
        <c:auto val="1"/>
        <c:lblAlgn val="ctr"/>
        <c:lblOffset val="100"/>
        <c:noMultiLvlLbl val="0"/>
      </c:catAx>
      <c:valAx>
        <c:axId val="45916024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lang="ja-JP" sz="1200">
                <a:latin typeface="+mn-lt"/>
              </a:defRPr>
            </a:pPr>
            <a:endParaRPr lang="en-US"/>
          </a:p>
        </c:txPr>
        <c:crossAx val="4591596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P2RY2</a:t>
            </a:r>
          </a:p>
        </c:rich>
      </c:tx>
      <c:layout>
        <c:manualLayout>
          <c:xMode val="edge"/>
          <c:yMode val="edge"/>
          <c:x val="0.79249190726159202"/>
          <c:y val="3.703703703703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7.3368110236220502E-2"/>
          <c:y val="4.4444444444444398E-2"/>
          <c:w val="0.89052077865266799"/>
          <c:h val="0.838210119568386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Z$4</c:f>
              <c:strCache>
                <c:ptCount val="1"/>
                <c:pt idx="0">
                  <c:v>P2RY2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'!$Z$11:$Z$14</c:f>
                <c:numCache>
                  <c:formatCode>General</c:formatCode>
                  <c:ptCount val="4"/>
                  <c:pt idx="0">
                    <c:v>7.5999999999999998E-2</c:v>
                  </c:pt>
                  <c:pt idx="1">
                    <c:v>4.3499999999999997E-2</c:v>
                  </c:pt>
                  <c:pt idx="2">
                    <c:v>9.7000000000000003E-3</c:v>
                  </c:pt>
                  <c:pt idx="3">
                    <c:v>2.4E-2</c:v>
                  </c:pt>
                </c:numCache>
              </c:numRef>
            </c:plus>
            <c:minus>
              <c:numRef>
                <c:f>'0'!$Z$11:$Z$14</c:f>
                <c:numCache>
                  <c:formatCode>General</c:formatCode>
                  <c:ptCount val="4"/>
                  <c:pt idx="0">
                    <c:v>7.5999999999999998E-2</c:v>
                  </c:pt>
                  <c:pt idx="1">
                    <c:v>4.3499999999999997E-2</c:v>
                  </c:pt>
                  <c:pt idx="2">
                    <c:v>9.7000000000000003E-3</c:v>
                  </c:pt>
                  <c:pt idx="3">
                    <c:v>2.4E-2</c:v>
                  </c:pt>
                </c:numCache>
              </c:numRef>
            </c:minus>
          </c:errBars>
          <c:cat>
            <c:strRef>
              <c:f>'0'!$Y$5:$Y$8</c:f>
              <c:strCache>
                <c:ptCount val="4"/>
                <c:pt idx="0">
                  <c:v>10A(P)</c:v>
                </c:pt>
                <c:pt idx="1">
                  <c:v>AT1</c:v>
                </c:pt>
                <c:pt idx="2">
                  <c:v>DCIS</c:v>
                </c:pt>
                <c:pt idx="3">
                  <c:v>CA1d</c:v>
                </c:pt>
              </c:strCache>
            </c:strRef>
          </c:cat>
          <c:val>
            <c:numRef>
              <c:f>'0'!$Z$5:$Z$8</c:f>
              <c:numCache>
                <c:formatCode>General</c:formatCode>
                <c:ptCount val="4"/>
                <c:pt idx="0">
                  <c:v>1</c:v>
                </c:pt>
                <c:pt idx="1">
                  <c:v>17.567</c:v>
                </c:pt>
                <c:pt idx="2">
                  <c:v>34.590000000000003</c:v>
                </c:pt>
                <c:pt idx="3">
                  <c:v>14.4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F47-D54D-994E-CD00299FFE0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9162480"/>
        <c:axId val="459163040"/>
      </c:barChart>
      <c:catAx>
        <c:axId val="4591624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59163040"/>
        <c:crosses val="autoZero"/>
        <c:auto val="1"/>
        <c:lblAlgn val="ctr"/>
        <c:lblOffset val="100"/>
        <c:noMultiLvlLbl val="0"/>
      </c:catAx>
      <c:valAx>
        <c:axId val="4591630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591624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1"/>
      </a:pPr>
      <a:endParaRPr lang="en-US"/>
    </a:p>
  </c:txPr>
  <c:externalData r:id="rId1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ZNF24</a:t>
            </a:r>
          </a:p>
        </c:rich>
      </c:tx>
      <c:layout>
        <c:manualLayout>
          <c:xMode val="edge"/>
          <c:yMode val="edge"/>
          <c:x val="0.76193635170603702"/>
          <c:y val="9.2592592592592605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7.3368110236220502E-2"/>
          <c:y val="4.4444444444444398E-2"/>
          <c:w val="0.89052077865266799"/>
          <c:h val="0.838210119568386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B$4</c:f>
              <c:strCache>
                <c:ptCount val="1"/>
                <c:pt idx="0">
                  <c:v>ZNF24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'!$AB$11:$AB$14</c:f>
                <c:numCache>
                  <c:formatCode>General</c:formatCode>
                  <c:ptCount val="4"/>
                  <c:pt idx="0">
                    <c:v>1.4999999999999999E-2</c:v>
                  </c:pt>
                  <c:pt idx="1">
                    <c:v>2.1999999999999999E-2</c:v>
                  </c:pt>
                  <c:pt idx="2">
                    <c:v>1.5299999999999999E-2</c:v>
                  </c:pt>
                  <c:pt idx="3">
                    <c:v>1.09E-2</c:v>
                  </c:pt>
                </c:numCache>
              </c:numRef>
            </c:plus>
            <c:minus>
              <c:numRef>
                <c:f>'0'!$AB$11:$AB$14</c:f>
                <c:numCache>
                  <c:formatCode>General</c:formatCode>
                  <c:ptCount val="4"/>
                  <c:pt idx="0">
                    <c:v>1.4999999999999999E-2</c:v>
                  </c:pt>
                  <c:pt idx="1">
                    <c:v>2.1999999999999999E-2</c:v>
                  </c:pt>
                  <c:pt idx="2">
                    <c:v>1.5299999999999999E-2</c:v>
                  </c:pt>
                  <c:pt idx="3">
                    <c:v>1.09E-2</c:v>
                  </c:pt>
                </c:numCache>
              </c:numRef>
            </c:minus>
          </c:errBars>
          <c:cat>
            <c:strRef>
              <c:f>'0'!$Y$5:$Y$8</c:f>
              <c:strCache>
                <c:ptCount val="4"/>
                <c:pt idx="0">
                  <c:v>10A(P)</c:v>
                </c:pt>
                <c:pt idx="1">
                  <c:v>AT1</c:v>
                </c:pt>
                <c:pt idx="2">
                  <c:v>DCIS</c:v>
                </c:pt>
                <c:pt idx="3">
                  <c:v>CA1d</c:v>
                </c:pt>
              </c:strCache>
            </c:strRef>
          </c:cat>
          <c:val>
            <c:numRef>
              <c:f>'0'!$AB$5:$AB$8</c:f>
              <c:numCache>
                <c:formatCode>General</c:formatCode>
                <c:ptCount val="4"/>
                <c:pt idx="0">
                  <c:v>1</c:v>
                </c:pt>
                <c:pt idx="1">
                  <c:v>1.76</c:v>
                </c:pt>
                <c:pt idx="2">
                  <c:v>2.19</c:v>
                </c:pt>
                <c:pt idx="3">
                  <c:v>2.738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383-8C44-908D-B483CA739A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9165280"/>
        <c:axId val="459165840"/>
      </c:barChart>
      <c:catAx>
        <c:axId val="4591652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59165840"/>
        <c:crosses val="autoZero"/>
        <c:auto val="1"/>
        <c:lblAlgn val="ctr"/>
        <c:lblOffset val="100"/>
        <c:noMultiLvlLbl val="0"/>
      </c:catAx>
      <c:valAx>
        <c:axId val="4591658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591652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1"/>
      </a:pPr>
      <a:endParaRPr lang="en-U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MARCKS</a:t>
            </a:r>
          </a:p>
        </c:rich>
      </c:tx>
      <c:layout>
        <c:manualLayout>
          <c:xMode val="edge"/>
          <c:yMode val="edge"/>
          <c:x val="0.79249190726159202"/>
          <c:y val="3.7037037037037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7.3368110236220502E-2"/>
          <c:y val="4.4444444444444398E-2"/>
          <c:w val="0.89052077865266799"/>
          <c:h val="0.838210119568386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A$4</c:f>
              <c:strCache>
                <c:ptCount val="1"/>
                <c:pt idx="0">
                  <c:v>MARKCS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'!$AA$11:$AA$14</c:f>
                <c:numCache>
                  <c:formatCode>General</c:formatCode>
                  <c:ptCount val="4"/>
                  <c:pt idx="0">
                    <c:v>2.87E-2</c:v>
                  </c:pt>
                  <c:pt idx="1">
                    <c:v>7.3400000000000007E-2</c:v>
                  </c:pt>
                  <c:pt idx="2">
                    <c:v>7.9000000000000008E-3</c:v>
                  </c:pt>
                  <c:pt idx="3">
                    <c:v>3.1699999999999999E-2</c:v>
                  </c:pt>
                </c:numCache>
              </c:numRef>
            </c:plus>
            <c:minus>
              <c:numRef>
                <c:f>'0'!$AA$11:$AA$14</c:f>
                <c:numCache>
                  <c:formatCode>General</c:formatCode>
                  <c:ptCount val="4"/>
                  <c:pt idx="0">
                    <c:v>2.87E-2</c:v>
                  </c:pt>
                  <c:pt idx="1">
                    <c:v>7.3400000000000007E-2</c:v>
                  </c:pt>
                  <c:pt idx="2">
                    <c:v>7.9000000000000008E-3</c:v>
                  </c:pt>
                  <c:pt idx="3">
                    <c:v>3.1699999999999999E-2</c:v>
                  </c:pt>
                </c:numCache>
              </c:numRef>
            </c:minus>
          </c:errBars>
          <c:cat>
            <c:strRef>
              <c:f>'0'!$Y$5:$Y$8</c:f>
              <c:strCache>
                <c:ptCount val="4"/>
                <c:pt idx="0">
                  <c:v>10A(P)</c:v>
                </c:pt>
                <c:pt idx="1">
                  <c:v>AT1</c:v>
                </c:pt>
                <c:pt idx="2">
                  <c:v>DCIS</c:v>
                </c:pt>
                <c:pt idx="3">
                  <c:v>CA1d</c:v>
                </c:pt>
              </c:strCache>
            </c:strRef>
          </c:cat>
          <c:val>
            <c:numRef>
              <c:f>'0'!$AA$5:$AA$8</c:f>
              <c:numCache>
                <c:formatCode>General</c:formatCode>
                <c:ptCount val="4"/>
                <c:pt idx="0">
                  <c:v>1</c:v>
                </c:pt>
                <c:pt idx="1">
                  <c:v>8.08</c:v>
                </c:pt>
                <c:pt idx="2">
                  <c:v>64.2</c:v>
                </c:pt>
                <c:pt idx="3">
                  <c:v>10.19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469-4249-A9BB-3AA870E7F3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9168080"/>
        <c:axId val="459168640"/>
      </c:barChart>
      <c:catAx>
        <c:axId val="4591680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59168640"/>
        <c:crosses val="autoZero"/>
        <c:auto val="1"/>
        <c:lblAlgn val="ctr"/>
        <c:lblOffset val="100"/>
        <c:noMultiLvlLbl val="0"/>
      </c:catAx>
      <c:valAx>
        <c:axId val="45916864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591680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1"/>
      </a:pPr>
      <a:endParaRPr lang="en-US"/>
    </a:p>
  </c:txPr>
  <c:externalData r:id="rId1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2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IDI1</a:t>
            </a:r>
          </a:p>
        </c:rich>
      </c:tx>
      <c:layout>
        <c:manualLayout>
          <c:xMode val="edge"/>
          <c:yMode val="edge"/>
          <c:x val="0.84970122484689403"/>
          <c:y val="8.33333333333333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7.8735131502972802E-2"/>
          <c:y val="4.2083051810646498E-2"/>
          <c:w val="0.87132392825896798"/>
          <c:h val="0.822422717993584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C$6</c:f>
              <c:strCache>
                <c:ptCount val="1"/>
                <c:pt idx="0">
                  <c:v>IDI1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lumMod val="110000"/>
                    <a:satMod val="105000"/>
                    <a:tint val="67000"/>
                  </a:schemeClr>
                </a:gs>
                <a:gs pos="50000">
                  <a:schemeClr val="dk1">
                    <a:tint val="88500"/>
                    <a:lumMod val="105000"/>
                    <a:satMod val="103000"/>
                    <a:tint val="73000"/>
                  </a:schemeClr>
                </a:gs>
                <a:gs pos="100000">
                  <a:schemeClr val="dk1">
                    <a:tint val="88500"/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S$7:$AS$10</c:f>
                <c:numCache>
                  <c:formatCode>General</c:formatCode>
                  <c:ptCount val="4"/>
                  <c:pt idx="0">
                    <c:v>2.9942192798594301E-2</c:v>
                  </c:pt>
                  <c:pt idx="1">
                    <c:v>8.7248234930041899E-2</c:v>
                  </c:pt>
                  <c:pt idx="2">
                    <c:v>9.1948201181731803E-2</c:v>
                  </c:pt>
                  <c:pt idx="3">
                    <c:v>4.7294456134656201E-2</c:v>
                  </c:pt>
                </c:numCache>
              </c:numRef>
            </c:plus>
            <c:minus>
              <c:numRef>
                <c:f>'0'!$AS$7:$AS$10</c:f>
                <c:numCache>
                  <c:formatCode>General</c:formatCode>
                  <c:ptCount val="4"/>
                  <c:pt idx="0">
                    <c:v>2.9942192798594301E-2</c:v>
                  </c:pt>
                  <c:pt idx="1">
                    <c:v>8.7248234930041899E-2</c:v>
                  </c:pt>
                  <c:pt idx="2">
                    <c:v>9.1948201181731803E-2</c:v>
                  </c:pt>
                  <c:pt idx="3">
                    <c:v>4.7294456134656201E-2</c:v>
                  </c:pt>
                </c:numCache>
              </c:numRef>
            </c:minus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0'!$Z$7:$Z$10</c:f>
              <c:strCache>
                <c:ptCount val="4"/>
                <c:pt idx="0">
                  <c:v>MCF10A (P)</c:v>
                </c:pt>
                <c:pt idx="1">
                  <c:v>MCF10.AT1</c:v>
                </c:pt>
                <c:pt idx="2">
                  <c:v>MCF10.DCIS</c:v>
                </c:pt>
                <c:pt idx="3">
                  <c:v>MCF10.Ca1d</c:v>
                </c:pt>
              </c:strCache>
            </c:strRef>
          </c:cat>
          <c:val>
            <c:numRef>
              <c:f>'0'!$AC$7:$AC$10</c:f>
              <c:numCache>
                <c:formatCode>0.000</c:formatCode>
                <c:ptCount val="4"/>
                <c:pt idx="0">
                  <c:v>1</c:v>
                </c:pt>
                <c:pt idx="1">
                  <c:v>1.9737100656941089</c:v>
                </c:pt>
                <c:pt idx="2">
                  <c:v>1.4825568975622381</c:v>
                </c:pt>
                <c:pt idx="3">
                  <c:v>0.766590303047486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997-E24B-BEC4-4AAF8F01B1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47178384"/>
        <c:axId val="447178944"/>
      </c:barChart>
      <c:catAx>
        <c:axId val="4471783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78944"/>
        <c:crosses val="autoZero"/>
        <c:auto val="1"/>
        <c:lblAlgn val="ctr"/>
        <c:lblOffset val="100"/>
        <c:noMultiLvlLbl val="0"/>
      </c:catAx>
      <c:valAx>
        <c:axId val="44717894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7838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2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SQLE</a:t>
            </a:r>
          </a:p>
        </c:rich>
      </c:tx>
      <c:layout>
        <c:manualLayout>
          <c:xMode val="edge"/>
          <c:yMode val="edge"/>
          <c:x val="0.84970122484689403"/>
          <c:y val="8.33333333333333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25649606299212E-2"/>
          <c:y val="4.2083333333333299E-2"/>
          <c:w val="0.87132392825896798"/>
          <c:h val="0.822422717993584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B$6</c:f>
              <c:strCache>
                <c:ptCount val="1"/>
                <c:pt idx="0">
                  <c:v>SQLE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lumMod val="110000"/>
                    <a:satMod val="105000"/>
                    <a:tint val="67000"/>
                  </a:schemeClr>
                </a:gs>
                <a:gs pos="50000">
                  <a:schemeClr val="dk1">
                    <a:tint val="88500"/>
                    <a:lumMod val="105000"/>
                    <a:satMod val="103000"/>
                    <a:tint val="73000"/>
                  </a:schemeClr>
                </a:gs>
                <a:gs pos="100000">
                  <a:schemeClr val="dk1">
                    <a:tint val="88500"/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R$7:$AR$10</c:f>
                <c:numCache>
                  <c:formatCode>General</c:formatCode>
                  <c:ptCount val="4"/>
                  <c:pt idx="0">
                    <c:v>2.5476546971944E-2</c:v>
                  </c:pt>
                  <c:pt idx="1">
                    <c:v>9.6556571095024801E-2</c:v>
                  </c:pt>
                  <c:pt idx="2">
                    <c:v>0.19973665009342301</c:v>
                  </c:pt>
                  <c:pt idx="3">
                    <c:v>5.2585080933666699E-2</c:v>
                  </c:pt>
                </c:numCache>
              </c:numRef>
            </c:plus>
            <c:minus>
              <c:numRef>
                <c:f>'0'!$AR$7:$AR$10</c:f>
                <c:numCache>
                  <c:formatCode>General</c:formatCode>
                  <c:ptCount val="4"/>
                  <c:pt idx="0">
                    <c:v>2.5476546971944E-2</c:v>
                  </c:pt>
                  <c:pt idx="1">
                    <c:v>9.6556571095024801E-2</c:v>
                  </c:pt>
                  <c:pt idx="2">
                    <c:v>0.19973665009342301</c:v>
                  </c:pt>
                  <c:pt idx="3">
                    <c:v>5.2585080933666699E-2</c:v>
                  </c:pt>
                </c:numCache>
              </c:numRef>
            </c:minus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0'!$Z$7:$Z$10</c:f>
              <c:strCache>
                <c:ptCount val="4"/>
                <c:pt idx="0">
                  <c:v>MCF10A (P)</c:v>
                </c:pt>
                <c:pt idx="1">
                  <c:v>MCF10.AT1</c:v>
                </c:pt>
                <c:pt idx="2">
                  <c:v>MCF10.DCIS</c:v>
                </c:pt>
                <c:pt idx="3">
                  <c:v>MCF10.Ca1d</c:v>
                </c:pt>
              </c:strCache>
            </c:strRef>
          </c:cat>
          <c:val>
            <c:numRef>
              <c:f>'0'!$AB$7:$AB$10</c:f>
              <c:numCache>
                <c:formatCode>0.000</c:formatCode>
                <c:ptCount val="4"/>
                <c:pt idx="0">
                  <c:v>1</c:v>
                </c:pt>
                <c:pt idx="1">
                  <c:v>2.3194703899582878</c:v>
                </c:pt>
                <c:pt idx="2">
                  <c:v>3.2235699089394378</c:v>
                </c:pt>
                <c:pt idx="3">
                  <c:v>0.688289684239324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016-F445-B42F-73B7BE5488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47181184"/>
        <c:axId val="447181744"/>
      </c:barChart>
      <c:catAx>
        <c:axId val="4471811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81744"/>
        <c:crosses val="autoZero"/>
        <c:auto val="1"/>
        <c:lblAlgn val="ctr"/>
        <c:lblOffset val="100"/>
        <c:noMultiLvlLbl val="0"/>
      </c:catAx>
      <c:valAx>
        <c:axId val="44718174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8118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2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CNBP</a:t>
            </a:r>
          </a:p>
        </c:rich>
      </c:tx>
      <c:layout>
        <c:manualLayout>
          <c:xMode val="edge"/>
          <c:yMode val="edge"/>
          <c:x val="0.84970122484689403"/>
          <c:y val="8.33333333333333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25649606299212E-2"/>
          <c:y val="4.2083333333333299E-2"/>
          <c:w val="0.87132392825896798"/>
          <c:h val="0.822422717993584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D$6</c:f>
              <c:strCache>
                <c:ptCount val="1"/>
                <c:pt idx="0">
                  <c:v>CNBP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lumMod val="110000"/>
                    <a:satMod val="105000"/>
                    <a:tint val="67000"/>
                  </a:schemeClr>
                </a:gs>
                <a:gs pos="50000">
                  <a:schemeClr val="dk1">
                    <a:tint val="88500"/>
                    <a:lumMod val="105000"/>
                    <a:satMod val="103000"/>
                    <a:tint val="73000"/>
                  </a:schemeClr>
                </a:gs>
                <a:gs pos="100000">
                  <a:schemeClr val="dk1">
                    <a:tint val="88500"/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T$7:$AT$10</c:f>
                <c:numCache>
                  <c:formatCode>General</c:formatCode>
                  <c:ptCount val="4"/>
                  <c:pt idx="0">
                    <c:v>3.8125335174244497E-2</c:v>
                  </c:pt>
                  <c:pt idx="1">
                    <c:v>0.135777952015989</c:v>
                  </c:pt>
                  <c:pt idx="2">
                    <c:v>0.23065558793902999</c:v>
                  </c:pt>
                  <c:pt idx="3">
                    <c:v>8.1764356367775001E-2</c:v>
                  </c:pt>
                </c:numCache>
              </c:numRef>
            </c:plus>
            <c:minus>
              <c:numRef>
                <c:f>'0'!$AT$7:$AT$10</c:f>
                <c:numCache>
                  <c:formatCode>General</c:formatCode>
                  <c:ptCount val="4"/>
                  <c:pt idx="0">
                    <c:v>3.8125335174244497E-2</c:v>
                  </c:pt>
                  <c:pt idx="1">
                    <c:v>0.135777952015989</c:v>
                  </c:pt>
                  <c:pt idx="2">
                    <c:v>0.23065558793902999</c:v>
                  </c:pt>
                  <c:pt idx="3">
                    <c:v>8.1764356367775001E-2</c:v>
                  </c:pt>
                </c:numCache>
              </c:numRef>
            </c:minus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0'!$Z$7:$Z$10</c:f>
              <c:strCache>
                <c:ptCount val="4"/>
                <c:pt idx="0">
                  <c:v>MCF10A (P)</c:v>
                </c:pt>
                <c:pt idx="1">
                  <c:v>MCF10.AT1</c:v>
                </c:pt>
                <c:pt idx="2">
                  <c:v>MCF10.DCIS</c:v>
                </c:pt>
                <c:pt idx="3">
                  <c:v>MCF10.Ca1d</c:v>
                </c:pt>
              </c:strCache>
            </c:strRef>
          </c:cat>
          <c:val>
            <c:numRef>
              <c:f>'0'!$AD$7:$AD$10</c:f>
              <c:numCache>
                <c:formatCode>0.000</c:formatCode>
                <c:ptCount val="4"/>
                <c:pt idx="0">
                  <c:v>1</c:v>
                </c:pt>
                <c:pt idx="1">
                  <c:v>2.9820143111409538</c:v>
                </c:pt>
                <c:pt idx="2">
                  <c:v>5.5508903530984046</c:v>
                </c:pt>
                <c:pt idx="3">
                  <c:v>1.402704988511547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567-934B-A660-6017147693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47183984"/>
        <c:axId val="447184544"/>
      </c:barChart>
      <c:catAx>
        <c:axId val="4471839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84544"/>
        <c:crosses val="autoZero"/>
        <c:auto val="1"/>
        <c:lblAlgn val="ctr"/>
        <c:lblOffset val="100"/>
        <c:noMultiLvlLbl val="0"/>
      </c:catAx>
      <c:valAx>
        <c:axId val="44718454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8398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2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DHCR7</a:t>
            </a:r>
          </a:p>
        </c:rich>
      </c:tx>
      <c:layout>
        <c:manualLayout>
          <c:xMode val="edge"/>
          <c:yMode val="edge"/>
          <c:x val="0.84970122484689403"/>
          <c:y val="8.33333333333333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369596650870699"/>
          <c:y val="3.7413295721764502E-2"/>
          <c:w val="0.87132392825896798"/>
          <c:h val="0.822422717993584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F$6</c:f>
              <c:strCache>
                <c:ptCount val="1"/>
                <c:pt idx="0">
                  <c:v>DHCR7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lumMod val="110000"/>
                    <a:satMod val="105000"/>
                    <a:tint val="67000"/>
                  </a:schemeClr>
                </a:gs>
                <a:gs pos="50000">
                  <a:schemeClr val="dk1">
                    <a:tint val="88500"/>
                    <a:lumMod val="105000"/>
                    <a:satMod val="103000"/>
                    <a:tint val="73000"/>
                  </a:schemeClr>
                </a:gs>
                <a:gs pos="100000">
                  <a:schemeClr val="dk1">
                    <a:tint val="88500"/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V$7:$AV$10</c:f>
                <c:numCache>
                  <c:formatCode>General</c:formatCode>
                  <c:ptCount val="4"/>
                  <c:pt idx="0">
                    <c:v>1.21809298235278E-2</c:v>
                  </c:pt>
                  <c:pt idx="1">
                    <c:v>6.6324112535462207E-2</c:v>
                  </c:pt>
                  <c:pt idx="2">
                    <c:v>1.3133658152269301E-2</c:v>
                  </c:pt>
                  <c:pt idx="3">
                    <c:v>5.3352162832250603E-2</c:v>
                  </c:pt>
                </c:numCache>
              </c:numRef>
            </c:plus>
            <c:minus>
              <c:numRef>
                <c:f>'0'!$AV$7:$AV$10</c:f>
                <c:numCache>
                  <c:formatCode>General</c:formatCode>
                  <c:ptCount val="4"/>
                  <c:pt idx="0">
                    <c:v>1.21809298235278E-2</c:v>
                  </c:pt>
                  <c:pt idx="1">
                    <c:v>6.6324112535462207E-2</c:v>
                  </c:pt>
                  <c:pt idx="2">
                    <c:v>1.3133658152269301E-2</c:v>
                  </c:pt>
                  <c:pt idx="3">
                    <c:v>5.3352162832250603E-2</c:v>
                  </c:pt>
                </c:numCache>
              </c:numRef>
            </c:minus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0'!$Z$7:$Z$10</c:f>
              <c:strCache>
                <c:ptCount val="4"/>
                <c:pt idx="0">
                  <c:v>MCF10A (P)</c:v>
                </c:pt>
                <c:pt idx="1">
                  <c:v>MCF10.AT1</c:v>
                </c:pt>
                <c:pt idx="2">
                  <c:v>MCF10.DCIS</c:v>
                </c:pt>
                <c:pt idx="3">
                  <c:v>MCF10.Ca1d</c:v>
                </c:pt>
              </c:strCache>
            </c:strRef>
          </c:cat>
          <c:val>
            <c:numRef>
              <c:f>'0'!$AF$7:$AF$10</c:f>
              <c:numCache>
                <c:formatCode>0.000</c:formatCode>
                <c:ptCount val="4"/>
                <c:pt idx="0">
                  <c:v>1</c:v>
                </c:pt>
                <c:pt idx="1">
                  <c:v>1.76628329843875</c:v>
                </c:pt>
                <c:pt idx="2">
                  <c:v>2.3179468046646261</c:v>
                </c:pt>
                <c:pt idx="3">
                  <c:v>0.7217108934375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1AD-524E-B291-FFCE0FA375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47186224"/>
        <c:axId val="447186784"/>
      </c:barChart>
      <c:catAx>
        <c:axId val="4471862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86784"/>
        <c:crosses val="autoZero"/>
        <c:auto val="1"/>
        <c:lblAlgn val="ctr"/>
        <c:lblOffset val="100"/>
        <c:noMultiLvlLbl val="0"/>
      </c:catAx>
      <c:valAx>
        <c:axId val="44718678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8622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2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FDFT1</a:t>
            </a:r>
          </a:p>
        </c:rich>
      </c:tx>
      <c:layout>
        <c:manualLayout>
          <c:xMode val="edge"/>
          <c:yMode val="edge"/>
          <c:x val="0.83430996479182185"/>
          <c:y val="6.02771794431902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25649606299212E-2"/>
          <c:y val="4.2083333333333299E-2"/>
          <c:w val="0.87132392825896798"/>
          <c:h val="0.822422717993584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G$6</c:f>
              <c:strCache>
                <c:ptCount val="1"/>
                <c:pt idx="0">
                  <c:v>FDFT1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lumMod val="110000"/>
                    <a:satMod val="105000"/>
                    <a:tint val="67000"/>
                  </a:schemeClr>
                </a:gs>
                <a:gs pos="50000">
                  <a:schemeClr val="dk1">
                    <a:tint val="88500"/>
                    <a:lumMod val="105000"/>
                    <a:satMod val="103000"/>
                    <a:tint val="73000"/>
                  </a:schemeClr>
                </a:gs>
                <a:gs pos="100000">
                  <a:schemeClr val="dk1">
                    <a:tint val="88500"/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W$7:$AW$10</c:f>
                <c:numCache>
                  <c:formatCode>General</c:formatCode>
                  <c:ptCount val="4"/>
                  <c:pt idx="0">
                    <c:v>1.9402846589289299E-2</c:v>
                  </c:pt>
                  <c:pt idx="1">
                    <c:v>0.125270270176257</c:v>
                  </c:pt>
                  <c:pt idx="2">
                    <c:v>0.121035146715924</c:v>
                  </c:pt>
                  <c:pt idx="3">
                    <c:v>5.8707076243607097E-2</c:v>
                  </c:pt>
                </c:numCache>
              </c:numRef>
            </c:plus>
            <c:minus>
              <c:numRef>
                <c:f>'0'!$AW$7:$AW$10</c:f>
                <c:numCache>
                  <c:formatCode>General</c:formatCode>
                  <c:ptCount val="4"/>
                  <c:pt idx="0">
                    <c:v>1.9402846589289299E-2</c:v>
                  </c:pt>
                  <c:pt idx="1">
                    <c:v>0.125270270176257</c:v>
                  </c:pt>
                  <c:pt idx="2">
                    <c:v>0.121035146715924</c:v>
                  </c:pt>
                  <c:pt idx="3">
                    <c:v>5.8707076243607097E-2</c:v>
                  </c:pt>
                </c:numCache>
              </c:numRef>
            </c:minus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0'!$Z$7:$Z$10</c:f>
              <c:strCache>
                <c:ptCount val="4"/>
                <c:pt idx="0">
                  <c:v>MCF10A (P)</c:v>
                </c:pt>
                <c:pt idx="1">
                  <c:v>MCF10.AT1</c:v>
                </c:pt>
                <c:pt idx="2">
                  <c:v>MCF10.DCIS</c:v>
                </c:pt>
                <c:pt idx="3">
                  <c:v>MCF10.Ca1d</c:v>
                </c:pt>
              </c:strCache>
            </c:strRef>
          </c:cat>
          <c:val>
            <c:numRef>
              <c:f>'0'!$AG$7:$AG$10</c:f>
              <c:numCache>
                <c:formatCode>0.000</c:formatCode>
                <c:ptCount val="4"/>
                <c:pt idx="0">
                  <c:v>1</c:v>
                </c:pt>
                <c:pt idx="1">
                  <c:v>3.0920352080510618</c:v>
                </c:pt>
                <c:pt idx="2">
                  <c:v>3.6587970808556909</c:v>
                </c:pt>
                <c:pt idx="3">
                  <c:v>1.70980860402951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9DD-364A-AC4B-F217D9E1DAF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47189024"/>
        <c:axId val="447189584"/>
      </c:barChart>
      <c:catAx>
        <c:axId val="4471890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89584"/>
        <c:crosses val="autoZero"/>
        <c:auto val="1"/>
        <c:lblAlgn val="ctr"/>
        <c:lblOffset val="100"/>
        <c:noMultiLvlLbl val="0"/>
      </c:catAx>
      <c:valAx>
        <c:axId val="44718958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8902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miR-210</a:t>
            </a:r>
          </a:p>
        </c:rich>
      </c:tx>
      <c:layout>
        <c:manualLayout>
          <c:xMode val="edge"/>
          <c:yMode val="edge"/>
          <c:x val="0.79716609716238296"/>
          <c:y val="5.4849485160508797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7.2869312243049295E-2"/>
          <c:y val="2.3076923076923099E-2"/>
          <c:w val="0.90279440457111004"/>
          <c:h val="0.855650514839490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2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L$3:$L$7</c:f>
                <c:numCache>
                  <c:formatCode>General</c:formatCode>
                  <c:ptCount val="5"/>
                  <c:pt idx="0">
                    <c:v>0.12066974595843</c:v>
                  </c:pt>
                  <c:pt idx="1">
                    <c:v>8.54503464203233E-2</c:v>
                  </c:pt>
                  <c:pt idx="2">
                    <c:v>0.16801385681293299</c:v>
                  </c:pt>
                  <c:pt idx="3">
                    <c:v>0.14376443418013901</c:v>
                  </c:pt>
                  <c:pt idx="4">
                    <c:v>0.27713625866050801</c:v>
                  </c:pt>
                </c:numCache>
              </c:numRef>
            </c:plus>
            <c:minus>
              <c:numRef>
                <c:f>Sheet1!$L$3:$L$7</c:f>
                <c:numCache>
                  <c:formatCode>General</c:formatCode>
                  <c:ptCount val="5"/>
                  <c:pt idx="0">
                    <c:v>0.12066974595843</c:v>
                  </c:pt>
                  <c:pt idx="1">
                    <c:v>8.54503464203233E-2</c:v>
                  </c:pt>
                  <c:pt idx="2">
                    <c:v>0.16801385681293299</c:v>
                  </c:pt>
                  <c:pt idx="3">
                    <c:v>0.14376443418013901</c:v>
                  </c:pt>
                  <c:pt idx="4">
                    <c:v>0.27713625866050801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1!$J$3:$J$7</c:f>
              <c:strCache>
                <c:ptCount val="5"/>
                <c:pt idx="0">
                  <c:v>MCF10A (P)</c:v>
                </c:pt>
                <c:pt idx="1">
                  <c:v>MCF10A neoT1</c:v>
                </c:pt>
                <c:pt idx="2">
                  <c:v>MCF10A AT1</c:v>
                </c:pt>
                <c:pt idx="3">
                  <c:v>MCF10A Ca1d</c:v>
                </c:pt>
                <c:pt idx="4">
                  <c:v>MCF10A ca1h</c:v>
                </c:pt>
              </c:strCache>
            </c:strRef>
          </c:cat>
          <c:val>
            <c:numRef>
              <c:f>Sheet1!$R$3:$R$7</c:f>
              <c:numCache>
                <c:formatCode>0.00</c:formatCode>
                <c:ptCount val="5"/>
                <c:pt idx="0">
                  <c:v>1</c:v>
                </c:pt>
                <c:pt idx="1">
                  <c:v>4.6199999999999957</c:v>
                </c:pt>
                <c:pt idx="2">
                  <c:v>0.66</c:v>
                </c:pt>
                <c:pt idx="3">
                  <c:v>3.5329999999999999</c:v>
                </c:pt>
                <c:pt idx="4">
                  <c:v>1.17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290F-1C4B-9B6F-C80D753D39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5621472"/>
        <c:axId val="445622032"/>
      </c:barChart>
      <c:catAx>
        <c:axId val="4456214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/>
          <a:lstStyle/>
          <a:p>
            <a:pPr>
              <a:defRPr sz="1200" b="1"/>
            </a:pPr>
            <a:endParaRPr lang="en-US"/>
          </a:p>
        </c:txPr>
        <c:crossAx val="445622032"/>
        <c:crosses val="autoZero"/>
        <c:auto val="1"/>
        <c:lblAlgn val="ctr"/>
        <c:lblOffset val="100"/>
        <c:noMultiLvlLbl val="0"/>
      </c:catAx>
      <c:valAx>
        <c:axId val="445622032"/>
        <c:scaling>
          <c:orientation val="minMax"/>
          <c:max val="5.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crossAx val="445621472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2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HSD17B7</a:t>
            </a:r>
          </a:p>
        </c:rich>
      </c:tx>
      <c:layout>
        <c:manualLayout>
          <c:xMode val="edge"/>
          <c:yMode val="edge"/>
          <c:x val="0.78265338960213293"/>
          <c:y val="0.1877877939774225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5.3606271773186102E-2"/>
          <c:y val="3.7502493229057098E-2"/>
          <c:w val="0.87132392825896798"/>
          <c:h val="0.822422717993584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H$6</c:f>
              <c:strCache>
                <c:ptCount val="1"/>
                <c:pt idx="0">
                  <c:v>HSD17B7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lumMod val="110000"/>
                    <a:satMod val="105000"/>
                    <a:tint val="67000"/>
                  </a:schemeClr>
                </a:gs>
                <a:gs pos="50000">
                  <a:schemeClr val="dk1">
                    <a:tint val="88500"/>
                    <a:lumMod val="105000"/>
                    <a:satMod val="103000"/>
                    <a:tint val="73000"/>
                  </a:schemeClr>
                </a:gs>
                <a:gs pos="100000">
                  <a:schemeClr val="dk1">
                    <a:tint val="88500"/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X$7:$AX$10</c:f>
                <c:numCache>
                  <c:formatCode>General</c:formatCode>
                  <c:ptCount val="4"/>
                  <c:pt idx="0">
                    <c:v>1.9737001664188802E-2</c:v>
                  </c:pt>
                  <c:pt idx="1">
                    <c:v>6.6422156349443595E-2</c:v>
                  </c:pt>
                  <c:pt idx="2">
                    <c:v>8.3819504383218196E-2</c:v>
                  </c:pt>
                  <c:pt idx="3">
                    <c:v>3.7961553915404803E-2</c:v>
                  </c:pt>
                </c:numCache>
              </c:numRef>
            </c:plus>
            <c:minus>
              <c:numRef>
                <c:f>'0'!$AX$7:$AX$10</c:f>
                <c:numCache>
                  <c:formatCode>General</c:formatCode>
                  <c:ptCount val="4"/>
                  <c:pt idx="0">
                    <c:v>1.9737001664188802E-2</c:v>
                  </c:pt>
                  <c:pt idx="1">
                    <c:v>6.6422156349443595E-2</c:v>
                  </c:pt>
                  <c:pt idx="2">
                    <c:v>8.3819504383218196E-2</c:v>
                  </c:pt>
                  <c:pt idx="3">
                    <c:v>3.7961553915404803E-2</c:v>
                  </c:pt>
                </c:numCache>
              </c:numRef>
            </c:minus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0'!$Z$7:$Z$10</c:f>
              <c:strCache>
                <c:ptCount val="4"/>
                <c:pt idx="0">
                  <c:v>MCF10A (P)</c:v>
                </c:pt>
                <c:pt idx="1">
                  <c:v>MCF10.AT1</c:v>
                </c:pt>
                <c:pt idx="2">
                  <c:v>MCF10.DCIS</c:v>
                </c:pt>
                <c:pt idx="3">
                  <c:v>MCF10.Ca1d</c:v>
                </c:pt>
              </c:strCache>
            </c:strRef>
          </c:cat>
          <c:val>
            <c:numRef>
              <c:f>'0'!$AH$7:$AH$10</c:f>
              <c:numCache>
                <c:formatCode>0.000</c:formatCode>
                <c:ptCount val="4"/>
                <c:pt idx="0">
                  <c:v>1</c:v>
                </c:pt>
                <c:pt idx="1">
                  <c:v>1.895277381040281</c:v>
                </c:pt>
                <c:pt idx="2">
                  <c:v>2.724108195581334</c:v>
                </c:pt>
                <c:pt idx="3">
                  <c:v>1.0206884459054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A53-3343-B290-2ACF094B99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47191824"/>
        <c:axId val="447192384"/>
      </c:barChart>
      <c:catAx>
        <c:axId val="4471918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92384"/>
        <c:crosses val="autoZero"/>
        <c:auto val="1"/>
        <c:lblAlgn val="ctr"/>
        <c:lblOffset val="100"/>
        <c:noMultiLvlLbl val="0"/>
      </c:catAx>
      <c:valAx>
        <c:axId val="44719238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4719182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2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TM7SF2</a:t>
            </a:r>
          </a:p>
        </c:rich>
      </c:tx>
      <c:layout>
        <c:manualLayout>
          <c:xMode val="edge"/>
          <c:yMode val="edge"/>
          <c:x val="0.76935044259074836"/>
          <c:y val="4.14422098239529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25649606299212E-2"/>
          <c:y val="4.2083333333333299E-2"/>
          <c:w val="0.87132392825896798"/>
          <c:h val="0.822422717993584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N$6</c:f>
              <c:strCache>
                <c:ptCount val="1"/>
                <c:pt idx="0">
                  <c:v>TM7SF2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lumMod val="110000"/>
                    <a:satMod val="105000"/>
                    <a:tint val="67000"/>
                  </a:schemeClr>
                </a:gs>
                <a:gs pos="50000">
                  <a:schemeClr val="dk1">
                    <a:tint val="88500"/>
                    <a:lumMod val="105000"/>
                    <a:satMod val="103000"/>
                    <a:tint val="73000"/>
                  </a:schemeClr>
                </a:gs>
                <a:gs pos="100000">
                  <a:schemeClr val="dk1">
                    <a:tint val="88500"/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BD$7:$BD$10</c:f>
                <c:numCache>
                  <c:formatCode>General</c:formatCode>
                  <c:ptCount val="4"/>
                  <c:pt idx="0">
                    <c:v>2.0186860802995098E-2</c:v>
                  </c:pt>
                  <c:pt idx="1">
                    <c:v>3.6746645071907898E-2</c:v>
                  </c:pt>
                  <c:pt idx="2">
                    <c:v>5.4803944837124002E-2</c:v>
                  </c:pt>
                  <c:pt idx="3">
                    <c:v>0.10177179026284899</c:v>
                  </c:pt>
                </c:numCache>
              </c:numRef>
            </c:plus>
            <c:minus>
              <c:numRef>
                <c:f>'0'!$BD$7:$BD$10</c:f>
                <c:numCache>
                  <c:formatCode>General</c:formatCode>
                  <c:ptCount val="4"/>
                  <c:pt idx="0">
                    <c:v>2.0186860802995098E-2</c:v>
                  </c:pt>
                  <c:pt idx="1">
                    <c:v>3.6746645071907898E-2</c:v>
                  </c:pt>
                  <c:pt idx="2">
                    <c:v>5.4803944837124002E-2</c:v>
                  </c:pt>
                  <c:pt idx="3">
                    <c:v>0.10177179026284899</c:v>
                  </c:pt>
                </c:numCache>
              </c:numRef>
            </c:minus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0'!$Z$7:$Z$10</c:f>
              <c:strCache>
                <c:ptCount val="4"/>
                <c:pt idx="0">
                  <c:v>MCF10A (P)</c:v>
                </c:pt>
                <c:pt idx="1">
                  <c:v>MCF10.AT1</c:v>
                </c:pt>
                <c:pt idx="2">
                  <c:v>MCF10.DCIS</c:v>
                </c:pt>
                <c:pt idx="3">
                  <c:v>MCF10.Ca1d</c:v>
                </c:pt>
              </c:strCache>
            </c:strRef>
          </c:cat>
          <c:val>
            <c:numRef>
              <c:f>'0'!$AN$7:$AN$10</c:f>
              <c:numCache>
                <c:formatCode>0.000</c:formatCode>
                <c:ptCount val="4"/>
                <c:pt idx="0">
                  <c:v>1</c:v>
                </c:pt>
                <c:pt idx="1">
                  <c:v>1.103220404135447</c:v>
                </c:pt>
                <c:pt idx="2">
                  <c:v>4.7391816457885403</c:v>
                </c:pt>
                <c:pt idx="3">
                  <c:v>1.3263262540334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9AA-EC4A-9D4D-85B42282EB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01318528"/>
        <c:axId val="401319088"/>
      </c:barChart>
      <c:catAx>
        <c:axId val="4013185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1319088"/>
        <c:crosses val="autoZero"/>
        <c:auto val="1"/>
        <c:lblAlgn val="ctr"/>
        <c:lblOffset val="100"/>
        <c:noMultiLvlLbl val="0"/>
      </c:catAx>
      <c:valAx>
        <c:axId val="401319088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131852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2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MVD</a:t>
            </a:r>
          </a:p>
        </c:rich>
      </c:tx>
      <c:layout>
        <c:manualLayout>
          <c:xMode val="edge"/>
          <c:yMode val="edge"/>
          <c:x val="0.72899360986304673"/>
          <c:y val="0.1259872138696096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25649606299212E-2"/>
          <c:y val="4.2083333333333299E-2"/>
          <c:w val="0.87132392825896798"/>
          <c:h val="0.822422717993584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J$6</c:f>
              <c:strCache>
                <c:ptCount val="1"/>
                <c:pt idx="0">
                  <c:v>MVD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lumMod val="110000"/>
                    <a:satMod val="105000"/>
                    <a:tint val="67000"/>
                  </a:schemeClr>
                </a:gs>
                <a:gs pos="50000">
                  <a:schemeClr val="dk1">
                    <a:tint val="88500"/>
                    <a:lumMod val="105000"/>
                    <a:satMod val="103000"/>
                    <a:tint val="73000"/>
                  </a:schemeClr>
                </a:gs>
                <a:gs pos="100000">
                  <a:schemeClr val="dk1">
                    <a:tint val="88500"/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AZ$7:$AZ$10</c:f>
                <c:numCache>
                  <c:formatCode>General</c:formatCode>
                  <c:ptCount val="4"/>
                  <c:pt idx="0">
                    <c:v>1.5417614726250899E-2</c:v>
                  </c:pt>
                  <c:pt idx="1">
                    <c:v>0.11217133153275299</c:v>
                  </c:pt>
                  <c:pt idx="2">
                    <c:v>9.1736370489290606E-2</c:v>
                  </c:pt>
                  <c:pt idx="3">
                    <c:v>3.62606401326689E-2</c:v>
                  </c:pt>
                </c:numCache>
              </c:numRef>
            </c:plus>
            <c:minus>
              <c:numRef>
                <c:f>'0'!$AZ$7:$AZ$10</c:f>
                <c:numCache>
                  <c:formatCode>General</c:formatCode>
                  <c:ptCount val="4"/>
                  <c:pt idx="0">
                    <c:v>1.5417614726250899E-2</c:v>
                  </c:pt>
                  <c:pt idx="1">
                    <c:v>0.11217133153275299</c:v>
                  </c:pt>
                  <c:pt idx="2">
                    <c:v>9.1736370489290606E-2</c:v>
                  </c:pt>
                  <c:pt idx="3">
                    <c:v>3.62606401326689E-2</c:v>
                  </c:pt>
                </c:numCache>
              </c:numRef>
            </c:minus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0'!$Z$7:$Z$10</c:f>
              <c:strCache>
                <c:ptCount val="4"/>
                <c:pt idx="0">
                  <c:v>MCF10A (P)</c:v>
                </c:pt>
                <c:pt idx="1">
                  <c:v>MCF10.AT1</c:v>
                </c:pt>
                <c:pt idx="2">
                  <c:v>MCF10.DCIS</c:v>
                </c:pt>
                <c:pt idx="3">
                  <c:v>MCF10.Ca1d</c:v>
                </c:pt>
              </c:strCache>
            </c:strRef>
          </c:cat>
          <c:val>
            <c:numRef>
              <c:f>'0'!$AJ$7:$AJ$10</c:f>
              <c:numCache>
                <c:formatCode>0.000</c:formatCode>
                <c:ptCount val="4"/>
                <c:pt idx="0">
                  <c:v>1</c:v>
                </c:pt>
                <c:pt idx="1">
                  <c:v>2.4335250471953618</c:v>
                </c:pt>
                <c:pt idx="2">
                  <c:v>2.920828624514026</c:v>
                </c:pt>
                <c:pt idx="3">
                  <c:v>1.5801683799844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32D-E448-9E73-36FB31F48C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01321328"/>
        <c:axId val="401321888"/>
      </c:barChart>
      <c:catAx>
        <c:axId val="4013213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1321888"/>
        <c:crosses val="autoZero"/>
        <c:auto val="1"/>
        <c:lblAlgn val="ctr"/>
        <c:lblOffset val="100"/>
        <c:noMultiLvlLbl val="0"/>
      </c:catAx>
      <c:valAx>
        <c:axId val="401321888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132132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2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DHCR24</a:t>
            </a:r>
          </a:p>
        </c:rich>
      </c:tx>
      <c:layout>
        <c:manualLayout>
          <c:xMode val="edge"/>
          <c:yMode val="edge"/>
          <c:x val="0.84970122484689403"/>
          <c:y val="8.33333333333333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25649606299212E-2"/>
          <c:y val="4.2083333333333299E-2"/>
          <c:w val="0.87132392825896798"/>
          <c:h val="0.822422717993584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K$6</c:f>
              <c:strCache>
                <c:ptCount val="1"/>
                <c:pt idx="0">
                  <c:v>DHCR24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lumMod val="110000"/>
                    <a:satMod val="105000"/>
                    <a:tint val="67000"/>
                  </a:schemeClr>
                </a:gs>
                <a:gs pos="50000">
                  <a:schemeClr val="dk1">
                    <a:tint val="88500"/>
                    <a:lumMod val="105000"/>
                    <a:satMod val="103000"/>
                    <a:tint val="73000"/>
                  </a:schemeClr>
                </a:gs>
                <a:gs pos="100000">
                  <a:schemeClr val="dk1">
                    <a:tint val="88500"/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BA$7:$BA$10</c:f>
                <c:numCache>
                  <c:formatCode>General</c:formatCode>
                  <c:ptCount val="4"/>
                  <c:pt idx="0">
                    <c:v>1.3258901878273799E-2</c:v>
                  </c:pt>
                  <c:pt idx="1">
                    <c:v>9.48688019691728E-2</c:v>
                  </c:pt>
                  <c:pt idx="2">
                    <c:v>0.129145303667521</c:v>
                  </c:pt>
                  <c:pt idx="3">
                    <c:v>0</c:v>
                  </c:pt>
                </c:numCache>
              </c:numRef>
            </c:plus>
            <c:minus>
              <c:numRef>
                <c:f>'0'!$BA$7:$BA$10</c:f>
                <c:numCache>
                  <c:formatCode>General</c:formatCode>
                  <c:ptCount val="4"/>
                  <c:pt idx="0">
                    <c:v>1.3258901878273799E-2</c:v>
                  </c:pt>
                  <c:pt idx="1">
                    <c:v>9.48688019691728E-2</c:v>
                  </c:pt>
                  <c:pt idx="2">
                    <c:v>0.129145303667521</c:v>
                  </c:pt>
                  <c:pt idx="3">
                    <c:v>0</c:v>
                  </c:pt>
                </c:numCache>
              </c:numRef>
            </c:minus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0'!$Z$7:$Z$10</c:f>
              <c:strCache>
                <c:ptCount val="4"/>
                <c:pt idx="0">
                  <c:v>MCF10A (P)</c:v>
                </c:pt>
                <c:pt idx="1">
                  <c:v>MCF10.AT1</c:v>
                </c:pt>
                <c:pt idx="2">
                  <c:v>MCF10.DCIS</c:v>
                </c:pt>
                <c:pt idx="3">
                  <c:v>MCF10.Ca1d</c:v>
                </c:pt>
              </c:strCache>
            </c:strRef>
          </c:cat>
          <c:val>
            <c:numRef>
              <c:f>'0'!$AK$7:$AK$10</c:f>
              <c:numCache>
                <c:formatCode>0.000</c:formatCode>
                <c:ptCount val="4"/>
                <c:pt idx="0">
                  <c:v>1</c:v>
                </c:pt>
                <c:pt idx="1">
                  <c:v>1.6635462572444251</c:v>
                </c:pt>
                <c:pt idx="2">
                  <c:v>3.0707591616603409</c:v>
                </c:pt>
                <c:pt idx="3">
                  <c:v>1.2000685674742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DA2-1545-AE1D-C8FC033DD7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01324128"/>
        <c:axId val="401324688"/>
      </c:barChart>
      <c:catAx>
        <c:axId val="4013241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1324688"/>
        <c:crosses val="autoZero"/>
        <c:auto val="1"/>
        <c:lblAlgn val="ctr"/>
        <c:lblOffset val="100"/>
        <c:noMultiLvlLbl val="0"/>
      </c:catAx>
      <c:valAx>
        <c:axId val="401324688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0132412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cap="none" spc="2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INSIG</a:t>
            </a:r>
          </a:p>
        </c:rich>
      </c:tx>
      <c:layout>
        <c:manualLayout>
          <c:xMode val="edge"/>
          <c:yMode val="edge"/>
          <c:x val="0.84970117732711492"/>
          <c:y val="0.1575381656689900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cap="none" spc="2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9.25649606299212E-2"/>
          <c:y val="4.2083333333333299E-2"/>
          <c:w val="0.87132392825896798"/>
          <c:h val="0.8224227179935840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AL$6</c:f>
              <c:strCache>
                <c:ptCount val="1"/>
                <c:pt idx="0">
                  <c:v>INSIG</c:v>
                </c:pt>
              </c:strCache>
            </c:strRef>
          </c:tx>
          <c:spPr>
            <a:gradFill rotWithShape="1">
              <a:gsLst>
                <a:gs pos="0">
                  <a:schemeClr val="dk1">
                    <a:tint val="88500"/>
                    <a:lumMod val="110000"/>
                    <a:satMod val="105000"/>
                    <a:tint val="67000"/>
                  </a:schemeClr>
                </a:gs>
                <a:gs pos="50000">
                  <a:schemeClr val="dk1">
                    <a:tint val="88500"/>
                    <a:lumMod val="105000"/>
                    <a:satMod val="103000"/>
                    <a:tint val="73000"/>
                  </a:schemeClr>
                </a:gs>
                <a:gs pos="100000">
                  <a:schemeClr val="dk1">
                    <a:tint val="88500"/>
                    <a:lumMod val="105000"/>
                    <a:satMod val="109000"/>
                    <a:tint val="81000"/>
                  </a:schemeClr>
                </a:gs>
              </a:gsLst>
              <a:lin ang="5400000" scaled="0"/>
            </a:gradFill>
            <a:ln w="9525" cap="flat" cmpd="sng" algn="ctr">
              <a:solidFill>
                <a:schemeClr val="dk1">
                  <a:tint val="88500"/>
                  <a:shade val="95000"/>
                </a:schemeClr>
              </a:solidFill>
              <a:round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0'!$BB$7:$BB$10</c:f>
                <c:numCache>
                  <c:formatCode>General</c:formatCode>
                  <c:ptCount val="4"/>
                  <c:pt idx="0">
                    <c:v>4.5086421141018802E-2</c:v>
                  </c:pt>
                  <c:pt idx="1">
                    <c:v>0.15010883422987101</c:v>
                  </c:pt>
                  <c:pt idx="2">
                    <c:v>5.6545616663817203E-2</c:v>
                  </c:pt>
                  <c:pt idx="3">
                    <c:v>3.5126486223241597E-2</c:v>
                  </c:pt>
                </c:numCache>
              </c:numRef>
            </c:plus>
            <c:minus>
              <c:numRef>
                <c:f>'0'!$BB$7:$BB$10</c:f>
                <c:numCache>
                  <c:formatCode>General</c:formatCode>
                  <c:ptCount val="4"/>
                  <c:pt idx="0">
                    <c:v>4.5086421141018802E-2</c:v>
                  </c:pt>
                  <c:pt idx="1">
                    <c:v>0.15010883422987101</c:v>
                  </c:pt>
                  <c:pt idx="2">
                    <c:v>5.6545616663817203E-2</c:v>
                  </c:pt>
                  <c:pt idx="3">
                    <c:v>3.5126486223241597E-2</c:v>
                  </c:pt>
                </c:numCache>
              </c:numRef>
            </c:minus>
            <c:spPr>
              <a:noFill/>
              <a:ln w="9525">
                <a:solidFill>
                  <a:sysClr val="windowText" lastClr="000000"/>
                </a:solidFill>
              </a:ln>
              <a:effectLst/>
            </c:spPr>
          </c:errBars>
          <c:cat>
            <c:strRef>
              <c:f>'0'!$Z$7:$Z$10</c:f>
              <c:strCache>
                <c:ptCount val="4"/>
                <c:pt idx="0">
                  <c:v>MCF10A (P)</c:v>
                </c:pt>
                <c:pt idx="1">
                  <c:v>MCF10.AT1</c:v>
                </c:pt>
                <c:pt idx="2">
                  <c:v>MCF10.DCIS</c:v>
                </c:pt>
                <c:pt idx="3">
                  <c:v>MCF10.Ca1d</c:v>
                </c:pt>
              </c:strCache>
            </c:strRef>
          </c:cat>
          <c:val>
            <c:numRef>
              <c:f>'0'!$AL$7:$AL$10</c:f>
              <c:numCache>
                <c:formatCode>0.000</c:formatCode>
                <c:ptCount val="4"/>
                <c:pt idx="0">
                  <c:v>1</c:v>
                </c:pt>
                <c:pt idx="1">
                  <c:v>2.8327532764782761</c:v>
                </c:pt>
                <c:pt idx="2">
                  <c:v>3.6155202415580621</c:v>
                </c:pt>
                <c:pt idx="3">
                  <c:v>1.10999616946327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D93-3A4D-B350-F37791E815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4"/>
        <c:axId val="459022384"/>
        <c:axId val="459022944"/>
      </c:barChart>
      <c:catAx>
        <c:axId val="4590223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9022944"/>
        <c:crosses val="autoZero"/>
        <c:auto val="1"/>
        <c:lblAlgn val="ctr"/>
        <c:lblOffset val="100"/>
        <c:noMultiLvlLbl val="0"/>
      </c:catAx>
      <c:valAx>
        <c:axId val="45902294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5902238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AA$5</c:f>
              <c:strCache>
                <c:ptCount val="1"/>
                <c:pt idx="0">
                  <c:v>Folds</c:v>
                </c:pt>
              </c:strCache>
            </c:strRef>
          </c:tx>
          <c:spPr>
            <a:noFill/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'!$AB$6:$AB$9</c:f>
                <c:numCache>
                  <c:formatCode>General</c:formatCode>
                  <c:ptCount val="4"/>
                  <c:pt idx="0">
                    <c:v>1.58941527046438E-2</c:v>
                  </c:pt>
                  <c:pt idx="1">
                    <c:v>8.8541282143922897E-3</c:v>
                  </c:pt>
                  <c:pt idx="2">
                    <c:v>9.3833770609132693E-3</c:v>
                  </c:pt>
                  <c:pt idx="3">
                    <c:v>1.8415541264430998E-2</c:v>
                  </c:pt>
                </c:numCache>
              </c:numRef>
            </c:plus>
            <c:minus>
              <c:numRef>
                <c:f>'0'!$AB$6:$AB$9</c:f>
                <c:numCache>
                  <c:formatCode>General</c:formatCode>
                  <c:ptCount val="4"/>
                  <c:pt idx="0">
                    <c:v>1.58941527046438E-2</c:v>
                  </c:pt>
                  <c:pt idx="1">
                    <c:v>8.8541282143922897E-3</c:v>
                  </c:pt>
                  <c:pt idx="2">
                    <c:v>9.3833770609132693E-3</c:v>
                  </c:pt>
                  <c:pt idx="3">
                    <c:v>1.8415541264430998E-2</c:v>
                  </c:pt>
                </c:numCache>
              </c:numRef>
            </c:minus>
          </c:errBars>
          <c:cat>
            <c:strRef>
              <c:f>'0'!$Z$6:$Z$9</c:f>
              <c:strCache>
                <c:ptCount val="4"/>
                <c:pt idx="0">
                  <c:v>MCF10A (P)</c:v>
                </c:pt>
                <c:pt idx="1">
                  <c:v>MCF10.AT1</c:v>
                </c:pt>
                <c:pt idx="2">
                  <c:v>MCF10.DCIS</c:v>
                </c:pt>
                <c:pt idx="3">
                  <c:v>MCF10.CA1d</c:v>
                </c:pt>
              </c:strCache>
            </c:strRef>
          </c:cat>
          <c:val>
            <c:numRef>
              <c:f>'0'!$AA$6:$AA$9</c:f>
              <c:numCache>
                <c:formatCode>General</c:formatCode>
                <c:ptCount val="4"/>
                <c:pt idx="0">
                  <c:v>1</c:v>
                </c:pt>
                <c:pt idx="1">
                  <c:v>0.33100000000000002</c:v>
                </c:pt>
                <c:pt idx="2">
                  <c:v>0.11799999999999999</c:v>
                </c:pt>
                <c:pt idx="3">
                  <c:v>0.2089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C1F-F847-9AEC-95FD8D31EB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5624272"/>
        <c:axId val="445624832"/>
      </c:barChart>
      <c:catAx>
        <c:axId val="4456242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45624832"/>
        <c:crosses val="autoZero"/>
        <c:auto val="1"/>
        <c:lblAlgn val="ctr"/>
        <c:lblOffset val="100"/>
        <c:noMultiLvlLbl val="0"/>
      </c:catAx>
      <c:valAx>
        <c:axId val="4456248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44562427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="1">
          <a:latin typeface="+mn-lt"/>
          <a:cs typeface="Arial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8.2294871368927006E-2"/>
          <c:y val="5.71656929980527E-2"/>
          <c:w val="0.91770511811023603"/>
          <c:h val="0.802500350822484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Z$11</c:f>
              <c:strCache>
                <c:ptCount val="1"/>
                <c:pt idx="0">
                  <c:v>DICER mRNA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'!$Y$7:$Z$7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5.0477717856495893E-2</c:v>
                  </c:pt>
                </c:numCache>
              </c:numRef>
            </c:plus>
            <c:minus>
              <c:numRef>
                <c:f>'0'!$Y$7:$Z$7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5.0477717856495893E-2</c:v>
                  </c:pt>
                </c:numCache>
              </c:numRef>
            </c:minus>
          </c:errBars>
          <c:cat>
            <c:strRef>
              <c:f>'0'!$AA$10:$AB$10</c:f>
              <c:strCache>
                <c:ptCount val="2"/>
                <c:pt idx="0">
                  <c:v>Scramble mimic</c:v>
                </c:pt>
                <c:pt idx="1">
                  <c:v>miR-29c-3p mimic</c:v>
                </c:pt>
              </c:strCache>
            </c:strRef>
          </c:cat>
          <c:val>
            <c:numRef>
              <c:f>'0'!$AA$11:$AB$11</c:f>
              <c:numCache>
                <c:formatCode>General</c:formatCode>
                <c:ptCount val="2"/>
                <c:pt idx="0">
                  <c:v>1</c:v>
                </c:pt>
                <c:pt idx="1">
                  <c:v>0.9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AAA-1845-8A6F-1F135AAA60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5627072"/>
        <c:axId val="445627632"/>
      </c:barChart>
      <c:catAx>
        <c:axId val="4456270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45627632"/>
        <c:crosses val="autoZero"/>
        <c:auto val="1"/>
        <c:lblAlgn val="ctr"/>
        <c:lblOffset val="100"/>
        <c:noMultiLvlLbl val="0"/>
      </c:catAx>
      <c:valAx>
        <c:axId val="44562763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44562707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="1">
          <a:latin typeface="Arial" charset="0"/>
          <a:ea typeface="Arial" charset="0"/>
          <a:cs typeface="Arial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8.2294871368927006E-2"/>
          <c:y val="5.71656929980527E-2"/>
          <c:w val="0.91770511811023603"/>
          <c:h val="0.802500350822484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S$13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Sheet1!$T$14:$T$15</c:f>
                <c:numCache>
                  <c:formatCode>General</c:formatCode>
                  <c:ptCount val="2"/>
                  <c:pt idx="0">
                    <c:v>0.127</c:v>
                  </c:pt>
                  <c:pt idx="1">
                    <c:v>2.5999999999999999E-2</c:v>
                  </c:pt>
                </c:numCache>
              </c:numRef>
            </c:plus>
            <c:minus>
              <c:numRef>
                <c:f>Sheet1!$T$14:$T$15</c:f>
                <c:numCache>
                  <c:formatCode>General</c:formatCode>
                  <c:ptCount val="2"/>
                  <c:pt idx="0">
                    <c:v>0.127</c:v>
                  </c:pt>
                  <c:pt idx="1">
                    <c:v>2.5999999999999999E-2</c:v>
                  </c:pt>
                </c:numCache>
              </c:numRef>
            </c:minus>
          </c:errBars>
          <c:cat>
            <c:strRef>
              <c:f>Sheet1!$R$14:$R$15</c:f>
              <c:strCache>
                <c:ptCount val="2"/>
                <c:pt idx="0">
                  <c:v>Scramble mimic</c:v>
                </c:pt>
                <c:pt idx="1">
                  <c:v>miR-29c-3p mimic</c:v>
                </c:pt>
              </c:strCache>
            </c:strRef>
          </c:cat>
          <c:val>
            <c:numRef>
              <c:f>Sheet1!$S$14:$S$15</c:f>
              <c:numCache>
                <c:formatCode>General</c:formatCode>
                <c:ptCount val="2"/>
                <c:pt idx="0">
                  <c:v>1.04</c:v>
                </c:pt>
                <c:pt idx="1">
                  <c:v>1.129999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AF4-A041-A7C2-FE557E6730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45629872"/>
        <c:axId val="445630432"/>
      </c:barChart>
      <c:catAx>
        <c:axId val="4456298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45630432"/>
        <c:crosses val="autoZero"/>
        <c:auto val="1"/>
        <c:lblAlgn val="ctr"/>
        <c:lblOffset val="100"/>
        <c:noMultiLvlLbl val="0"/>
      </c:catAx>
      <c:valAx>
        <c:axId val="445630432"/>
        <c:scaling>
          <c:orientation val="minMax"/>
          <c:max val="2"/>
        </c:scaling>
        <c:delete val="0"/>
        <c:axPos val="l"/>
        <c:numFmt formatCode="General" sourceLinked="1"/>
        <c:majorTickMark val="out"/>
        <c:minorTickMark val="none"/>
        <c:tickLblPos val="nextTo"/>
        <c:crossAx val="445629872"/>
        <c:crosses val="autoZero"/>
        <c:crossBetween val="between"/>
        <c:majorUnit val="0.5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 b="1">
          <a:latin typeface="Arial" charset="0"/>
          <a:ea typeface="Arial" charset="0"/>
          <a:cs typeface="Arial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W$7</c:f>
              <c:strCache>
                <c:ptCount val="1"/>
                <c:pt idx="0">
                  <c:v>TIAN1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'!$W$38:$W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4.355302201990581</c:v>
                  </c:pt>
                  <c:pt idx="2">
                    <c:v>7.5196343944216304</c:v>
                  </c:pt>
                  <c:pt idx="3">
                    <c:v>37.586724528283433</c:v>
                  </c:pt>
                </c:numCache>
              </c:numRef>
            </c:plus>
            <c:minus>
              <c:numRef>
                <c:f>'0'!$W$38:$W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4.355302201990581</c:v>
                  </c:pt>
                  <c:pt idx="2">
                    <c:v>7.5196343944216304</c:v>
                  </c:pt>
                  <c:pt idx="3">
                    <c:v>37.586724528283433</c:v>
                  </c:pt>
                </c:numCache>
              </c:numRef>
            </c:minus>
          </c:errBars>
          <c:cat>
            <c:strRef>
              <c:f>'0'!$V$8:$V$11</c:f>
              <c:strCache>
                <c:ptCount val="4"/>
                <c:pt idx="0">
                  <c:v>10A</c:v>
                </c:pt>
                <c:pt idx="1">
                  <c:v>AT1</c:v>
                </c:pt>
                <c:pt idx="2">
                  <c:v>DCIS</c:v>
                </c:pt>
                <c:pt idx="3">
                  <c:v>Ca1d</c:v>
                </c:pt>
              </c:strCache>
            </c:strRef>
          </c:cat>
          <c:val>
            <c:numRef>
              <c:f>'0'!$W$8:$W$11</c:f>
              <c:numCache>
                <c:formatCode>0.00</c:formatCode>
                <c:ptCount val="4"/>
                <c:pt idx="0">
                  <c:v>1</c:v>
                </c:pt>
                <c:pt idx="1">
                  <c:v>135.0885866212121</c:v>
                </c:pt>
                <c:pt idx="2">
                  <c:v>96.517308885775762</c:v>
                </c:pt>
                <c:pt idx="3">
                  <c:v>194.9726404793206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087-7E46-A168-7AB4603E9AC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4719440"/>
        <c:axId val="394720000"/>
      </c:barChart>
      <c:catAx>
        <c:axId val="3947194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394720000"/>
        <c:crosses val="autoZero"/>
        <c:auto val="1"/>
        <c:lblAlgn val="ctr"/>
        <c:lblOffset val="100"/>
        <c:noMultiLvlLbl val="0"/>
      </c:catAx>
      <c:valAx>
        <c:axId val="39472000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3947194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134415206585559"/>
          <c:y val="0.230198894143434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9.9580068145746103E-2"/>
          <c:y val="0.11776660652700301"/>
          <c:w val="0.85768648194220498"/>
          <c:h val="0.717912409475512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0'!$X$7</c:f>
              <c:strCache>
                <c:ptCount val="1"/>
                <c:pt idx="0">
                  <c:v>USP6NL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'!$X$38:$X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7850752668596259</c:v>
                  </c:pt>
                  <c:pt idx="2">
                    <c:v>11.66234419041106</c:v>
                  </c:pt>
                  <c:pt idx="3">
                    <c:v>3.997850436426837</c:v>
                  </c:pt>
                </c:numCache>
              </c:numRef>
            </c:plus>
            <c:minus>
              <c:numRef>
                <c:f>'0'!$X$38:$X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1.7850752668596259</c:v>
                  </c:pt>
                  <c:pt idx="2">
                    <c:v>11.66234419041106</c:v>
                  </c:pt>
                  <c:pt idx="3">
                    <c:v>3.997850436426837</c:v>
                  </c:pt>
                </c:numCache>
              </c:numRef>
            </c:minus>
          </c:errBars>
          <c:cat>
            <c:strRef>
              <c:f>'0'!$V$8:$V$11</c:f>
              <c:strCache>
                <c:ptCount val="4"/>
                <c:pt idx="0">
                  <c:v>10A</c:v>
                </c:pt>
                <c:pt idx="1">
                  <c:v>AT1</c:v>
                </c:pt>
                <c:pt idx="2">
                  <c:v>DCIS</c:v>
                </c:pt>
                <c:pt idx="3">
                  <c:v>Ca1d</c:v>
                </c:pt>
              </c:strCache>
            </c:strRef>
          </c:cat>
          <c:val>
            <c:numRef>
              <c:f>'0'!$X$8:$X$11</c:f>
              <c:numCache>
                <c:formatCode>0.00</c:formatCode>
                <c:ptCount val="4"/>
                <c:pt idx="0">
                  <c:v>1</c:v>
                </c:pt>
                <c:pt idx="1">
                  <c:v>36.006504110078232</c:v>
                </c:pt>
                <c:pt idx="2">
                  <c:v>55.910696835564202</c:v>
                </c:pt>
                <c:pt idx="3">
                  <c:v>40.98716782410510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4D2-5B4F-89A4-9D7E9BF0CE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4722240"/>
        <c:axId val="394722800"/>
      </c:barChart>
      <c:catAx>
        <c:axId val="3947222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394722800"/>
        <c:crosses val="autoZero"/>
        <c:auto val="1"/>
        <c:lblAlgn val="ctr"/>
        <c:lblOffset val="100"/>
        <c:noMultiLvlLbl val="0"/>
      </c:catAx>
      <c:valAx>
        <c:axId val="39472280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3947222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14380003742736799"/>
          <c:y val="0.23581350131766399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Y$7</c:f>
              <c:strCache>
                <c:ptCount val="1"/>
                <c:pt idx="0">
                  <c:v>ADAM12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'!$Y$38:$Y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1.65414994661343</c:v>
                  </c:pt>
                  <c:pt idx="2">
                    <c:v>8.133780384523428</c:v>
                  </c:pt>
                  <c:pt idx="3">
                    <c:v>11.5816276331777</c:v>
                  </c:pt>
                </c:numCache>
              </c:numRef>
            </c:plus>
            <c:minus>
              <c:numRef>
                <c:f>'0'!$Y$38:$Y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1.65414994661343</c:v>
                  </c:pt>
                  <c:pt idx="2">
                    <c:v>8.133780384523428</c:v>
                  </c:pt>
                  <c:pt idx="3">
                    <c:v>11.5816276331777</c:v>
                  </c:pt>
                </c:numCache>
              </c:numRef>
            </c:minus>
          </c:errBars>
          <c:cat>
            <c:strRef>
              <c:f>'0'!$V$8:$V$11</c:f>
              <c:strCache>
                <c:ptCount val="4"/>
                <c:pt idx="0">
                  <c:v>10A</c:v>
                </c:pt>
                <c:pt idx="1">
                  <c:v>AT1</c:v>
                </c:pt>
                <c:pt idx="2">
                  <c:v>DCIS</c:v>
                </c:pt>
                <c:pt idx="3">
                  <c:v>Ca1d</c:v>
                </c:pt>
              </c:strCache>
            </c:strRef>
          </c:cat>
          <c:val>
            <c:numRef>
              <c:f>'0'!$Y$8:$Y$11</c:f>
              <c:numCache>
                <c:formatCode>0.00</c:formatCode>
                <c:ptCount val="4"/>
                <c:pt idx="0">
                  <c:v>1</c:v>
                </c:pt>
                <c:pt idx="1">
                  <c:v>204.10695605814519</c:v>
                </c:pt>
                <c:pt idx="2">
                  <c:v>352.59904375989697</c:v>
                </c:pt>
                <c:pt idx="3">
                  <c:v>244.352221375235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FFC-E245-A9C2-30004142939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94725040"/>
        <c:axId val="394725600"/>
      </c:barChart>
      <c:catAx>
        <c:axId val="3947250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394725600"/>
        <c:crosses val="autoZero"/>
        <c:auto val="1"/>
        <c:lblAlgn val="ctr"/>
        <c:lblOffset val="100"/>
        <c:noMultiLvlLbl val="0"/>
      </c:catAx>
      <c:valAx>
        <c:axId val="39472560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3947250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12378105455621299"/>
          <c:y val="0.23019879237368701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0'!$AB$7</c:f>
              <c:strCache>
                <c:ptCount val="1"/>
                <c:pt idx="0">
                  <c:v>FKBP4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0'!$AB$38:$AB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1509478869302256</c:v>
                  </c:pt>
                  <c:pt idx="2">
                    <c:v>9.6886941232074673</c:v>
                  </c:pt>
                  <c:pt idx="3">
                    <c:v>15.445060608477769</c:v>
                  </c:pt>
                </c:numCache>
              </c:numRef>
            </c:plus>
            <c:minus>
              <c:numRef>
                <c:f>'0'!$AB$38:$AB$41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6.1509478869302256</c:v>
                  </c:pt>
                  <c:pt idx="2">
                    <c:v>9.6886941232074673</c:v>
                  </c:pt>
                  <c:pt idx="3">
                    <c:v>15.445060608477769</c:v>
                  </c:pt>
                </c:numCache>
              </c:numRef>
            </c:minus>
          </c:errBars>
          <c:cat>
            <c:strRef>
              <c:f>'0'!$V$8:$V$11</c:f>
              <c:strCache>
                <c:ptCount val="4"/>
                <c:pt idx="0">
                  <c:v>10A</c:v>
                </c:pt>
                <c:pt idx="1">
                  <c:v>AT1</c:v>
                </c:pt>
                <c:pt idx="2">
                  <c:v>DCIS</c:v>
                </c:pt>
                <c:pt idx="3">
                  <c:v>Ca1d</c:v>
                </c:pt>
              </c:strCache>
            </c:strRef>
          </c:cat>
          <c:val>
            <c:numRef>
              <c:f>'0'!$AB$8:$AB$11</c:f>
              <c:numCache>
                <c:formatCode>0.00</c:formatCode>
                <c:ptCount val="4"/>
                <c:pt idx="0">
                  <c:v>1</c:v>
                </c:pt>
                <c:pt idx="1">
                  <c:v>25.545784015091151</c:v>
                </c:pt>
                <c:pt idx="2">
                  <c:v>47.040346628287729</c:v>
                </c:pt>
                <c:pt idx="3">
                  <c:v>54.94787203982549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3AF-6242-B3FB-E1D0524A011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59154080"/>
        <c:axId val="459154640"/>
      </c:barChart>
      <c:catAx>
        <c:axId val="4591540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459154640"/>
        <c:crosses val="autoZero"/>
        <c:auto val="1"/>
        <c:lblAlgn val="ctr"/>
        <c:lblOffset val="100"/>
        <c:noMultiLvlLbl val="0"/>
      </c:catAx>
      <c:valAx>
        <c:axId val="45915464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/>
            </a:pPr>
            <a:endParaRPr lang="en-US"/>
          </a:p>
        </c:txPr>
        <c:crossAx val="4591540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10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8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9.xml><?xml version="1.0" encoding="utf-8"?>
<cs:chartStyle xmlns:cs="http://schemas.microsoft.com/office/drawing/2012/chartStyle" xmlns:a="http://schemas.openxmlformats.org/drawingml/2006/main" id="206">
  <cs:axisTitle>
    <cs:lnRef idx="0"/>
    <cs:fillRef idx="0"/>
    <cs:effectRef idx="0"/>
    <cs:fontRef idx="minor">
      <a:schemeClr val="tx1">
        <a:lumMod val="50000"/>
        <a:lumOff val="50000"/>
      </a:schemeClr>
    </cs:fontRef>
    <cs:defRPr sz="900" kern="1200" cap="all"/>
  </cs:axisTitle>
  <cs:category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>
  <cs:dataPoint3D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3D>
  <cs:dataPointLine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158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2">
      <cs:styleClr val="auto"/>
    </cs:fillRef>
    <cs:effectRef idx="1"/>
    <cs:fontRef idx="minor">
      <a:schemeClr val="dk1"/>
    </cs:fontRef>
    <cs:spPr>
      <a:ln w="9525" cap="flat" cmpd="sng" algn="ctr">
        <a:solidFill>
          <a:schemeClr val="phClr">
            <a:shade val="95000"/>
          </a:schemeClr>
        </a:solidFill>
        <a:round/>
      </a:ln>
    </cs:spPr>
  </cs:dataPointMarker>
  <cs:dataPointMarkerLayout symbol="circle" size="4"/>
  <cs:dataPointWirefram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50000"/>
        <a:lumOff val="50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50000"/>
        <a:lumOff val="50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prstDash val="dash"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1400" kern="1200" cap="none" spc="20" baseline="0"/>
  </cs:title>
  <cs:trendline>
    <cs:lnRef idx="0">
      <cs:styleClr val="auto"/>
    </cs:lnRef>
    <cs:fillRef idx="2"/>
    <cs:effectRef idx="0"/>
    <cs:fontRef idx="minor">
      <a:schemeClr val="dk1"/>
    </cs:fontRef>
    <cs:spPr>
      <a:ln w="9525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50000"/>
        <a:lumOff val="50000"/>
      </a:schemeClr>
    </cs:fontRef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318CCB-36B5-2040-9E68-97026937FC7B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6467CC-3C7F-E44E-A1CC-7DA3997A81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18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AB#209, RNA </a:t>
            </a:r>
            <a:r>
              <a:rPr lang="mr-IN" dirty="0"/>
              <a:t>–</a:t>
            </a:r>
            <a:r>
              <a:rPr lang="en-US" dirty="0"/>
              <a:t> KZ-9/2015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99A12D9-24EA-BD49-8F58-1998B57128ED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25196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E6467CC-3C7F-E44E-A1CC-7DA3997A81FB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4192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206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8567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9927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216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7470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3543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434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810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777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622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863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106B43-8711-4488-99ED-C75EDB3F0318}" type="datetimeFigureOut">
              <a:rPr lang="en-US" smtClean="0"/>
              <a:t>3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BC2A07-0866-4A2B-88FF-193E77185D0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847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8.xml"/><Relationship Id="rId5" Type="http://schemas.openxmlformats.org/officeDocument/2006/relationships/chart" Target="../charts/chart17.xml"/><Relationship Id="rId4" Type="http://schemas.openxmlformats.org/officeDocument/2006/relationships/chart" Target="../charts/chart16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7" Type="http://schemas.openxmlformats.org/officeDocument/2006/relationships/chart" Target="../charts/chart24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3.xml"/><Relationship Id="rId5" Type="http://schemas.openxmlformats.org/officeDocument/2006/relationships/chart" Target="../charts/chart22.xml"/><Relationship Id="rId4" Type="http://schemas.openxmlformats.org/officeDocument/2006/relationships/chart" Target="../charts/chart2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f"/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9.tif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tiff"/><Relationship Id="rId2" Type="http://schemas.openxmlformats.org/officeDocument/2006/relationships/image" Target="../media/image22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tiff"/><Relationship Id="rId4" Type="http://schemas.openxmlformats.org/officeDocument/2006/relationships/image" Target="../media/image5.tif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7" Type="http://schemas.openxmlformats.org/officeDocument/2006/relationships/chart" Target="../charts/chart11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0.xml"/><Relationship Id="rId5" Type="http://schemas.openxmlformats.org/officeDocument/2006/relationships/chart" Target="../charts/chart9.xml"/><Relationship Id="rId4" Type="http://schemas.openxmlformats.org/officeDocument/2006/relationships/chart" Target="../charts/chart8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2" Type="http://schemas.openxmlformats.org/officeDocument/2006/relationships/chart" Target="../charts/chart12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489770"/>
            <a:ext cx="34051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verall miRNA expression patterns</a:t>
            </a:r>
          </a:p>
          <a:p>
            <a:r>
              <a:rPr lang="en-US" dirty="0">
                <a:solidFill>
                  <a:srgbClr val="FF0000"/>
                </a:solidFill>
              </a:rPr>
              <a:t>(n=450)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2AD3417F-6C30-EF4B-A741-95F4451D2FC0}"/>
              </a:ext>
            </a:extLst>
          </p:cNvPr>
          <p:cNvSpPr/>
          <p:nvPr/>
        </p:nvSpPr>
        <p:spPr>
          <a:xfrm>
            <a:off x="10107992" y="6298898"/>
            <a:ext cx="17546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S1. </a:t>
            </a:r>
            <a:endParaRPr lang="en-US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0DB18DBF-DDBB-D143-B9B7-F7A9CC593047}"/>
              </a:ext>
            </a:extLst>
          </p:cNvPr>
          <p:cNvSpPr txBox="1"/>
          <p:nvPr/>
        </p:nvSpPr>
        <p:spPr>
          <a:xfrm>
            <a:off x="0" y="0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C4737209-CB9E-044D-9F73-B9892CE9B5E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75531"/>
            <a:ext cx="12192000" cy="41069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2292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4" name="Chart 3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47715273"/>
              </p:ext>
            </p:extLst>
          </p:nvPr>
        </p:nvGraphicFramePr>
        <p:xfrm>
          <a:off x="928060" y="2958043"/>
          <a:ext cx="3744326" cy="224921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6" name="Chart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9114127"/>
              </p:ext>
            </p:extLst>
          </p:nvPr>
        </p:nvGraphicFramePr>
        <p:xfrm>
          <a:off x="5581625" y="1039625"/>
          <a:ext cx="4409520" cy="21553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7" name="Chart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04220093"/>
              </p:ext>
            </p:extLst>
          </p:nvPr>
        </p:nvGraphicFramePr>
        <p:xfrm>
          <a:off x="5628358" y="2952366"/>
          <a:ext cx="4409520" cy="23054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46" name="TextBox 45"/>
          <p:cNvSpPr txBox="1"/>
          <p:nvPr/>
        </p:nvSpPr>
        <p:spPr>
          <a:xfrm rot="16200000">
            <a:off x="-221161" y="1541015"/>
            <a:ext cx="1570086" cy="455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2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179" dirty="0">
                <a:latin typeface="Arial"/>
                <a:cs typeface="Arial"/>
              </a:rPr>
              <a:t>mRNA expression (fold)</a:t>
            </a:r>
          </a:p>
        </p:txBody>
      </p:sp>
      <p:sp>
        <p:nvSpPr>
          <p:cNvPr id="47" name="TextBox 46"/>
          <p:cNvSpPr txBox="1"/>
          <p:nvPr/>
        </p:nvSpPr>
        <p:spPr>
          <a:xfrm rot="16200000">
            <a:off x="-161431" y="3501036"/>
            <a:ext cx="1570086" cy="455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2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179" dirty="0">
                <a:latin typeface="Arial"/>
                <a:cs typeface="Arial"/>
              </a:rPr>
              <a:t>mRNA expression (fold)</a:t>
            </a:r>
          </a:p>
        </p:txBody>
      </p:sp>
      <p:sp>
        <p:nvSpPr>
          <p:cNvPr id="49" name="TextBox 48"/>
          <p:cNvSpPr txBox="1"/>
          <p:nvPr/>
        </p:nvSpPr>
        <p:spPr>
          <a:xfrm rot="16200000">
            <a:off x="4756237" y="2082160"/>
            <a:ext cx="1570086" cy="455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2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179" dirty="0">
                <a:latin typeface="Arial"/>
                <a:cs typeface="Arial"/>
              </a:rPr>
              <a:t>mRNA expression (fold)</a:t>
            </a:r>
          </a:p>
        </p:txBody>
      </p:sp>
      <p:sp>
        <p:nvSpPr>
          <p:cNvPr id="50" name="TextBox 49"/>
          <p:cNvSpPr txBox="1"/>
          <p:nvPr/>
        </p:nvSpPr>
        <p:spPr>
          <a:xfrm rot="16200000">
            <a:off x="4796581" y="3775219"/>
            <a:ext cx="1570086" cy="4552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2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179" dirty="0">
                <a:latin typeface="Arial"/>
                <a:cs typeface="Arial"/>
              </a:rPr>
              <a:t>mRNA expression (fold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30503027-D26B-C046-8E29-99BD256B433A}"/>
              </a:ext>
            </a:extLst>
          </p:cNvPr>
          <p:cNvSpPr txBox="1"/>
          <p:nvPr/>
        </p:nvSpPr>
        <p:spPr>
          <a:xfrm>
            <a:off x="8230100" y="5657629"/>
            <a:ext cx="18077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</a:t>
            </a:r>
            <a:r>
              <a:rPr lang="en-US" b="1" dirty="0" smtClean="0"/>
              <a:t>S10.</a:t>
            </a:r>
            <a:endParaRPr lang="en-US" dirty="0"/>
          </a:p>
        </p:txBody>
      </p:sp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xmlns="" id="{81ED712F-F4DF-5540-AA33-91BEADF516B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1535905"/>
              </p:ext>
            </p:extLst>
          </p:nvPr>
        </p:nvGraphicFramePr>
        <p:xfrm>
          <a:off x="774364" y="791546"/>
          <a:ext cx="4228653" cy="22480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84149A52-410B-454A-9FE1-4D80CA7DBB21}"/>
              </a:ext>
            </a:extLst>
          </p:cNvPr>
          <p:cNvSpPr txBox="1"/>
          <p:nvPr/>
        </p:nvSpPr>
        <p:spPr>
          <a:xfrm>
            <a:off x="2447127" y="134005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5852CED1-8A8E-C64A-A54C-8DFB892DD87B}"/>
              </a:ext>
            </a:extLst>
          </p:cNvPr>
          <p:cNvSpPr txBox="1"/>
          <p:nvPr/>
        </p:nvSpPr>
        <p:spPr>
          <a:xfrm>
            <a:off x="2297086" y="337815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2BC7053D-0F43-A542-A126-D3CB3B8D1459}"/>
              </a:ext>
            </a:extLst>
          </p:cNvPr>
          <p:cNvSpPr txBox="1"/>
          <p:nvPr/>
        </p:nvSpPr>
        <p:spPr>
          <a:xfrm>
            <a:off x="7344196" y="385706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DA77622D-20E3-BF44-BB2D-0B57ADBBCABD}"/>
              </a:ext>
            </a:extLst>
          </p:cNvPr>
          <p:cNvSpPr txBox="1"/>
          <p:nvPr/>
        </p:nvSpPr>
        <p:spPr>
          <a:xfrm>
            <a:off x="7297541" y="158356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xmlns="" id="{018B20D1-F8BA-0C4D-9078-DB0F2C46AC88}"/>
              </a:ext>
            </a:extLst>
          </p:cNvPr>
          <p:cNvSpPr/>
          <p:nvPr/>
        </p:nvSpPr>
        <p:spPr>
          <a:xfrm>
            <a:off x="184666" y="138919"/>
            <a:ext cx="189638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/>
              <a:t>Gene Valida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134434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3035061"/>
              </p:ext>
            </p:extLst>
          </p:nvPr>
        </p:nvGraphicFramePr>
        <p:xfrm>
          <a:off x="237971" y="1648422"/>
          <a:ext cx="4125746" cy="2203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16619049"/>
              </p:ext>
            </p:extLst>
          </p:nvPr>
        </p:nvGraphicFramePr>
        <p:xfrm>
          <a:off x="423922" y="3587611"/>
          <a:ext cx="3822130" cy="20376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8726938"/>
              </p:ext>
            </p:extLst>
          </p:nvPr>
        </p:nvGraphicFramePr>
        <p:xfrm>
          <a:off x="4257834" y="3608657"/>
          <a:ext cx="3967209" cy="2122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6" name="TextBox 15"/>
          <p:cNvSpPr txBox="1"/>
          <p:nvPr/>
        </p:nvSpPr>
        <p:spPr>
          <a:xfrm rot="16200000">
            <a:off x="-1218115" y="3292040"/>
            <a:ext cx="2724706" cy="2737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defRPr sz="1200" b="1" i="0" u="none" strike="noStrike" kern="1200" baseline="0">
                <a:solidFill>
                  <a:prstClr val="black"/>
                </a:solidFill>
                <a:latin typeface="+mn-lt"/>
                <a:ea typeface="+mn-ea"/>
                <a:cs typeface="+mn-cs"/>
              </a:defRPr>
            </a:pPr>
            <a:r>
              <a:rPr lang="en-US" sz="1179" dirty="0">
                <a:latin typeface="Arial"/>
                <a:cs typeface="Arial"/>
              </a:rPr>
              <a:t>mRNA expression (fold)</a:t>
            </a:r>
          </a:p>
        </p:txBody>
      </p:sp>
      <p:graphicFrame>
        <p:nvGraphicFramePr>
          <p:cNvPr id="26" name="Chart 25">
            <a:extLst>
              <a:ext uri="{FF2B5EF4-FFF2-40B4-BE49-F238E27FC236}">
                <a16:creationId xmlns:a16="http://schemas.microsoft.com/office/drawing/2014/main" xmlns="" id="{E4D3F595-A861-304C-B4B0-F8DB56E3DB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3131286"/>
              </p:ext>
            </p:extLst>
          </p:nvPr>
        </p:nvGraphicFramePr>
        <p:xfrm>
          <a:off x="4244909" y="1276757"/>
          <a:ext cx="4208517" cy="23819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7" name="Chart 26">
            <a:extLst>
              <a:ext uri="{FF2B5EF4-FFF2-40B4-BE49-F238E27FC236}">
                <a16:creationId xmlns:a16="http://schemas.microsoft.com/office/drawing/2014/main" xmlns="" id="{E7D6AFDF-0CA8-4C4B-BCF7-D58DF21DBE1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17699031"/>
              </p:ext>
            </p:extLst>
          </p:nvPr>
        </p:nvGraphicFramePr>
        <p:xfrm>
          <a:off x="7983483" y="1311261"/>
          <a:ext cx="4208517" cy="21043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8" name="Chart 27">
            <a:extLst>
              <a:ext uri="{FF2B5EF4-FFF2-40B4-BE49-F238E27FC236}">
                <a16:creationId xmlns:a16="http://schemas.microsoft.com/office/drawing/2014/main" xmlns="" id="{1CDFE63E-54E6-1F4C-8F8D-D293E78E344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41219566"/>
              </p:ext>
            </p:extLst>
          </p:nvPr>
        </p:nvGraphicFramePr>
        <p:xfrm>
          <a:off x="7973132" y="3378428"/>
          <a:ext cx="4208516" cy="23960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2" name="TextBox 31">
            <a:extLst>
              <a:ext uri="{FF2B5EF4-FFF2-40B4-BE49-F238E27FC236}">
                <a16:creationId xmlns:a16="http://schemas.microsoft.com/office/drawing/2014/main" xmlns="" id="{76398F51-D88B-7F49-87D7-201725F65218}"/>
              </a:ext>
            </a:extLst>
          </p:cNvPr>
          <p:cNvSpPr txBox="1"/>
          <p:nvPr/>
        </p:nvSpPr>
        <p:spPr>
          <a:xfrm>
            <a:off x="10310808" y="6365297"/>
            <a:ext cx="1870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</a:t>
            </a:r>
            <a:r>
              <a:rPr lang="en-US" b="1" dirty="0" smtClean="0"/>
              <a:t>S11.</a:t>
            </a:r>
            <a:endParaRPr lang="en-US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39EE42A8-A81C-054A-889F-C45E0439DA73}"/>
              </a:ext>
            </a:extLst>
          </p:cNvPr>
          <p:cNvSpPr txBox="1"/>
          <p:nvPr/>
        </p:nvSpPr>
        <p:spPr>
          <a:xfrm>
            <a:off x="1845164" y="184205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AFE7EF9D-7E4E-F142-B30A-3815A674DEB8}"/>
              </a:ext>
            </a:extLst>
          </p:cNvPr>
          <p:cNvSpPr txBox="1"/>
          <p:nvPr/>
        </p:nvSpPr>
        <p:spPr>
          <a:xfrm>
            <a:off x="1790652" y="400325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2F4DFFB2-EF41-E34D-957F-AC8765FE3F76}"/>
              </a:ext>
            </a:extLst>
          </p:cNvPr>
          <p:cNvSpPr txBox="1"/>
          <p:nvPr/>
        </p:nvSpPr>
        <p:spPr>
          <a:xfrm>
            <a:off x="6683004" y="380130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718D629A-6953-2048-9918-188C4C2166D9}"/>
              </a:ext>
            </a:extLst>
          </p:cNvPr>
          <p:cNvSpPr txBox="1"/>
          <p:nvPr/>
        </p:nvSpPr>
        <p:spPr>
          <a:xfrm>
            <a:off x="9587936" y="366709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4DA3CC11-A0F8-484D-A7FD-D6EC407A35F3}"/>
              </a:ext>
            </a:extLst>
          </p:cNvPr>
          <p:cNvSpPr txBox="1"/>
          <p:nvPr/>
        </p:nvSpPr>
        <p:spPr>
          <a:xfrm>
            <a:off x="10543758" y="149842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BC1C8ADB-FE30-734F-BF59-710B18C72880}"/>
              </a:ext>
            </a:extLst>
          </p:cNvPr>
          <p:cNvSpPr txBox="1"/>
          <p:nvPr/>
        </p:nvSpPr>
        <p:spPr>
          <a:xfrm>
            <a:off x="5883781" y="183043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xmlns="" id="{B9ED463F-DBB9-BA4B-93A6-FDAA9DD03BDF}"/>
              </a:ext>
            </a:extLst>
          </p:cNvPr>
          <p:cNvSpPr/>
          <p:nvPr/>
        </p:nvSpPr>
        <p:spPr>
          <a:xfrm>
            <a:off x="184666" y="138919"/>
            <a:ext cx="189638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/>
              <a:t>Gene Valida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8667362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8946" y="421267"/>
            <a:ext cx="5978868" cy="5300336"/>
          </a:xfrm>
          <a:prstGeom prst="rect">
            <a:avLst/>
          </a:prstGeom>
          <a:ln>
            <a:solidFill>
              <a:schemeClr val="accent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B290848C-4E03-2A43-9BB4-69D2C97DAD71}"/>
              </a:ext>
            </a:extLst>
          </p:cNvPr>
          <p:cNvSpPr txBox="1"/>
          <p:nvPr/>
        </p:nvSpPr>
        <p:spPr>
          <a:xfrm>
            <a:off x="5520267" y="6372953"/>
            <a:ext cx="19430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</a:t>
            </a:r>
            <a:r>
              <a:rPr lang="en-US" b="1" dirty="0" smtClean="0"/>
              <a:t>S12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4038298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430260" y="6469786"/>
            <a:ext cx="18087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</a:t>
            </a:r>
            <a:r>
              <a:rPr lang="en-US" b="1" dirty="0" smtClean="0"/>
              <a:t>S13. 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88AF936C-3F6C-8D46-AD93-AAB7F86B08C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841" y="287868"/>
            <a:ext cx="6658492" cy="59089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201089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A348E41F-C8A7-A442-B47D-FE344805708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5900" y="4538555"/>
            <a:ext cx="7531941" cy="206704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234269" y="755200"/>
            <a:ext cx="9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roup 1</a:t>
            </a:r>
          </a:p>
        </p:txBody>
      </p:sp>
      <p:grpSp>
        <p:nvGrpSpPr>
          <p:cNvPr id="64" name="Group 63"/>
          <p:cNvGrpSpPr/>
          <p:nvPr/>
        </p:nvGrpSpPr>
        <p:grpSpPr>
          <a:xfrm>
            <a:off x="285750" y="1074465"/>
            <a:ext cx="3590531" cy="3498026"/>
            <a:chOff x="3117178" y="65314"/>
            <a:chExt cx="6055851" cy="6589449"/>
          </a:xfrm>
        </p:grpSpPr>
        <p:cxnSp>
          <p:nvCxnSpPr>
            <p:cNvPr id="65" name="Straight Connector 64"/>
            <p:cNvCxnSpPr/>
            <p:nvPr/>
          </p:nvCxnSpPr>
          <p:spPr>
            <a:xfrm>
              <a:off x="3280257" y="2986523"/>
              <a:ext cx="5519351" cy="823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>
              <a:off x="3117178" y="6125143"/>
              <a:ext cx="1030633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Normal</a:t>
              </a: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868027" y="6125143"/>
              <a:ext cx="973856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Benign</a:t>
              </a:r>
            </a:p>
          </p:txBody>
        </p:sp>
        <p:cxnSp>
          <p:nvCxnSpPr>
            <p:cNvPr id="68" name="Straight Connector 67"/>
            <p:cNvCxnSpPr/>
            <p:nvPr/>
          </p:nvCxnSpPr>
          <p:spPr>
            <a:xfrm>
              <a:off x="3722044" y="2883882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Connector 68"/>
            <p:cNvCxnSpPr/>
            <p:nvPr/>
          </p:nvCxnSpPr>
          <p:spPr>
            <a:xfrm>
              <a:off x="5367342" y="2878044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Straight Connector 69"/>
            <p:cNvCxnSpPr/>
            <p:nvPr/>
          </p:nvCxnSpPr>
          <p:spPr>
            <a:xfrm>
              <a:off x="7032211" y="2878044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Straight Connector 70"/>
            <p:cNvCxnSpPr/>
            <p:nvPr/>
          </p:nvCxnSpPr>
          <p:spPr>
            <a:xfrm>
              <a:off x="8561019" y="2886282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>
            <a:xfrm flipV="1">
              <a:off x="3722044" y="143040"/>
              <a:ext cx="4838975" cy="2843483"/>
            </a:xfrm>
            <a:prstGeom prst="line">
              <a:avLst/>
            </a:prstGeom>
            <a:ln w="5715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3722044" y="2994761"/>
              <a:ext cx="4918103" cy="3166524"/>
            </a:xfrm>
            <a:prstGeom prst="line">
              <a:avLst/>
            </a:prstGeom>
            <a:ln w="19050">
              <a:solidFill>
                <a:srgbClr val="00B05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>
            <a:xfrm flipV="1">
              <a:off x="3722044" y="2186444"/>
              <a:ext cx="1577744" cy="800079"/>
            </a:xfrm>
            <a:prstGeom prst="line">
              <a:avLst/>
            </a:prstGeom>
            <a:ln w="19050">
              <a:solidFill>
                <a:srgbClr val="FF000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74"/>
            <p:cNvCxnSpPr/>
            <p:nvPr/>
          </p:nvCxnSpPr>
          <p:spPr>
            <a:xfrm flipV="1">
              <a:off x="5288215" y="2130461"/>
              <a:ext cx="3272803" cy="65314"/>
            </a:xfrm>
            <a:prstGeom prst="line">
              <a:avLst/>
            </a:prstGeom>
            <a:ln w="19050">
              <a:solidFill>
                <a:srgbClr val="FF000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3797560" y="2978285"/>
              <a:ext cx="1496442" cy="824130"/>
            </a:xfrm>
            <a:prstGeom prst="line">
              <a:avLst/>
            </a:prstGeom>
            <a:ln w="19050">
              <a:solidFill>
                <a:srgbClr val="00B05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>
              <a:off x="5288215" y="3802415"/>
              <a:ext cx="3288986" cy="110192"/>
            </a:xfrm>
            <a:prstGeom prst="line">
              <a:avLst/>
            </a:prstGeom>
            <a:ln w="19050">
              <a:solidFill>
                <a:srgbClr val="00B05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 flipV="1">
              <a:off x="5367342" y="2354395"/>
              <a:ext cx="3193676" cy="623890"/>
            </a:xfrm>
            <a:prstGeom prst="line">
              <a:avLst/>
            </a:prstGeom>
            <a:ln w="19050">
              <a:solidFill>
                <a:srgbClr val="FF000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Straight Connector 78"/>
            <p:cNvCxnSpPr/>
            <p:nvPr/>
          </p:nvCxnSpPr>
          <p:spPr>
            <a:xfrm>
              <a:off x="5448827" y="2999488"/>
              <a:ext cx="3105890" cy="794689"/>
            </a:xfrm>
            <a:prstGeom prst="line">
              <a:avLst/>
            </a:prstGeom>
            <a:ln w="19050">
              <a:solidFill>
                <a:srgbClr val="00B05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/>
            <p:nvPr/>
          </p:nvCxnSpPr>
          <p:spPr>
            <a:xfrm flipV="1">
              <a:off x="7077086" y="2635054"/>
              <a:ext cx="1458300" cy="343231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>
              <a:off x="7081395" y="3017844"/>
              <a:ext cx="1424139" cy="386102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/>
            <p:cNvSpPr txBox="1"/>
            <p:nvPr/>
          </p:nvSpPr>
          <p:spPr>
            <a:xfrm>
              <a:off x="6527953" y="6161952"/>
              <a:ext cx="752157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DCIS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8278803" y="6161952"/>
              <a:ext cx="844081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CA1D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8588496" y="65314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G1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8588498" y="1861391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2</a:t>
              </a: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8588496" y="2149793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3</a:t>
              </a: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8588496" y="2457395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4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8588496" y="3193112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5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8588496" y="3559498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6</a:t>
              </a: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8588496" y="3761205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7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8588496" y="5935512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8</a:t>
              </a:r>
            </a:p>
          </p:txBody>
        </p:sp>
        <p:sp>
          <p:nvSpPr>
            <p:cNvPr id="92" name="Rectangle 91"/>
            <p:cNvSpPr/>
            <p:nvPr/>
          </p:nvSpPr>
          <p:spPr>
            <a:xfrm>
              <a:off x="3117178" y="65314"/>
              <a:ext cx="5918877" cy="6521603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</p:grpSp>
      <p:sp>
        <p:nvSpPr>
          <p:cNvPr id="6" name="TextBox 5"/>
          <p:cNvSpPr txBox="1"/>
          <p:nvPr/>
        </p:nvSpPr>
        <p:spPr>
          <a:xfrm>
            <a:off x="10449549" y="6558479"/>
            <a:ext cx="19530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</a:t>
            </a:r>
            <a:r>
              <a:rPr lang="en-US" b="1" dirty="0" smtClean="0"/>
              <a:t>S14.</a:t>
            </a: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6215DACA-F223-2C49-9A81-18D82D20B70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48047" y="0"/>
            <a:ext cx="7549795" cy="22571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C396E246-ED6B-6D4C-9B34-8E0E1EB4647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2778" y="2293074"/>
            <a:ext cx="7526597" cy="2209533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414217425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7178" y="551935"/>
            <a:ext cx="9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roup 3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157162" y="1117328"/>
            <a:ext cx="3590531" cy="3498026"/>
            <a:chOff x="3117178" y="65314"/>
            <a:chExt cx="6055851" cy="6589449"/>
          </a:xfrm>
        </p:grpSpPr>
        <p:cxnSp>
          <p:nvCxnSpPr>
            <p:cNvPr id="8" name="Straight Connector 7"/>
            <p:cNvCxnSpPr/>
            <p:nvPr/>
          </p:nvCxnSpPr>
          <p:spPr>
            <a:xfrm>
              <a:off x="3280257" y="2986523"/>
              <a:ext cx="5519351" cy="823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3117178" y="6125143"/>
              <a:ext cx="1030633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Normal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868027" y="6125143"/>
              <a:ext cx="973856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Benign</a:t>
              </a:r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3722044" y="2883882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5367342" y="2878044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7032211" y="2878044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8561019" y="2886282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flipV="1">
              <a:off x="3722044" y="143040"/>
              <a:ext cx="4838975" cy="2843483"/>
            </a:xfrm>
            <a:prstGeom prst="line">
              <a:avLst/>
            </a:prstGeom>
            <a:ln w="127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3722044" y="2994761"/>
              <a:ext cx="4918103" cy="3166524"/>
            </a:xfrm>
            <a:prstGeom prst="line">
              <a:avLst/>
            </a:prstGeom>
            <a:ln w="19050">
              <a:solidFill>
                <a:srgbClr val="00B05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flipV="1">
              <a:off x="3722044" y="2186444"/>
              <a:ext cx="1577744" cy="800079"/>
            </a:xfrm>
            <a:prstGeom prst="line">
              <a:avLst/>
            </a:prstGeom>
            <a:ln w="12700">
              <a:solidFill>
                <a:srgbClr val="FF000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V="1">
              <a:off x="5288215" y="2130461"/>
              <a:ext cx="3272803" cy="65314"/>
            </a:xfrm>
            <a:prstGeom prst="line">
              <a:avLst/>
            </a:prstGeom>
            <a:ln w="12700">
              <a:solidFill>
                <a:srgbClr val="FF000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3797560" y="2978285"/>
              <a:ext cx="1496442" cy="824130"/>
            </a:xfrm>
            <a:prstGeom prst="line">
              <a:avLst/>
            </a:prstGeom>
            <a:ln w="19050">
              <a:solidFill>
                <a:srgbClr val="00B05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5288215" y="3802415"/>
              <a:ext cx="3288986" cy="110192"/>
            </a:xfrm>
            <a:prstGeom prst="line">
              <a:avLst/>
            </a:prstGeom>
            <a:ln w="19050">
              <a:solidFill>
                <a:srgbClr val="00B05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V="1">
              <a:off x="5367342" y="2354395"/>
              <a:ext cx="3193676" cy="623890"/>
            </a:xfrm>
            <a:prstGeom prst="line">
              <a:avLst/>
            </a:prstGeom>
            <a:ln w="57150">
              <a:solidFill>
                <a:srgbClr val="FF000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5448827" y="2999488"/>
              <a:ext cx="3105890" cy="794689"/>
            </a:xfrm>
            <a:prstGeom prst="line">
              <a:avLst/>
            </a:prstGeom>
            <a:ln w="19050">
              <a:solidFill>
                <a:srgbClr val="00B05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flipV="1">
              <a:off x="7077086" y="2635054"/>
              <a:ext cx="1458300" cy="343231"/>
            </a:xfrm>
            <a:prstGeom prst="line">
              <a:avLst/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7081395" y="3017844"/>
              <a:ext cx="1424139" cy="386102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6527953" y="6161952"/>
              <a:ext cx="752157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DCIS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8278803" y="6161952"/>
              <a:ext cx="844081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CA1D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588496" y="65314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1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8588498" y="1861391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2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8588496" y="2149793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G3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588496" y="2457395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4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8588496" y="3193112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5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8588496" y="3559498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6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588496" y="3761205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7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588496" y="5935512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8</a:t>
              </a: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3117178" y="65314"/>
              <a:ext cx="5918877" cy="6521603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44EFDACC-F3DC-914D-BC27-066CEFDF32DA}"/>
              </a:ext>
            </a:extLst>
          </p:cNvPr>
          <p:cNvSpPr txBox="1"/>
          <p:nvPr/>
        </p:nvSpPr>
        <p:spPr>
          <a:xfrm>
            <a:off x="7835586" y="4898006"/>
            <a:ext cx="18386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</a:t>
            </a:r>
            <a:r>
              <a:rPr lang="en-US" b="1" dirty="0" smtClean="0"/>
              <a:t>S15.</a:t>
            </a:r>
            <a:endParaRPr lang="en-US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6440F77F-0443-BF48-AB44-7B41307A177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6569" y="1111108"/>
            <a:ext cx="5485084" cy="15874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xmlns="" id="{4022BC24-619F-514F-BB5C-DA20B051702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6569" y="2839738"/>
            <a:ext cx="5485084" cy="1655410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028378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87178" y="551935"/>
            <a:ext cx="9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roup 4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114300" y="1217340"/>
            <a:ext cx="3590531" cy="3498026"/>
            <a:chOff x="3117178" y="65314"/>
            <a:chExt cx="6055851" cy="6589449"/>
          </a:xfrm>
        </p:grpSpPr>
        <p:cxnSp>
          <p:nvCxnSpPr>
            <p:cNvPr id="9" name="Straight Connector 8"/>
            <p:cNvCxnSpPr/>
            <p:nvPr/>
          </p:nvCxnSpPr>
          <p:spPr>
            <a:xfrm>
              <a:off x="3280257" y="2986523"/>
              <a:ext cx="5519351" cy="823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3117178" y="6125143"/>
              <a:ext cx="1030633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Normal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68027" y="6125143"/>
              <a:ext cx="973856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Benign</a:t>
              </a:r>
            </a:p>
          </p:txBody>
        </p:sp>
        <p:cxnSp>
          <p:nvCxnSpPr>
            <p:cNvPr id="12" name="Straight Connector 11"/>
            <p:cNvCxnSpPr/>
            <p:nvPr/>
          </p:nvCxnSpPr>
          <p:spPr>
            <a:xfrm>
              <a:off x="3722044" y="2883882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5367342" y="2878044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7032211" y="2878044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8561019" y="2886282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V="1">
              <a:off x="3722044" y="143040"/>
              <a:ext cx="4838975" cy="2843483"/>
            </a:xfrm>
            <a:prstGeom prst="line">
              <a:avLst/>
            </a:prstGeom>
            <a:ln w="127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3722044" y="2994761"/>
              <a:ext cx="4918103" cy="3166524"/>
            </a:xfrm>
            <a:prstGeom prst="line">
              <a:avLst/>
            </a:prstGeom>
            <a:ln w="19050">
              <a:solidFill>
                <a:srgbClr val="00B05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V="1">
              <a:off x="3722044" y="2186444"/>
              <a:ext cx="1577744" cy="800079"/>
            </a:xfrm>
            <a:prstGeom prst="line">
              <a:avLst/>
            </a:prstGeom>
            <a:ln w="12700">
              <a:solidFill>
                <a:srgbClr val="FF000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V="1">
              <a:off x="5288215" y="2130461"/>
              <a:ext cx="3272803" cy="65314"/>
            </a:xfrm>
            <a:prstGeom prst="line">
              <a:avLst/>
            </a:prstGeom>
            <a:ln w="12700">
              <a:solidFill>
                <a:srgbClr val="FF000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3797560" y="2978285"/>
              <a:ext cx="1496442" cy="824130"/>
            </a:xfrm>
            <a:prstGeom prst="line">
              <a:avLst/>
            </a:prstGeom>
            <a:ln w="19050">
              <a:solidFill>
                <a:srgbClr val="00B05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5288215" y="3802415"/>
              <a:ext cx="3288986" cy="110192"/>
            </a:xfrm>
            <a:prstGeom prst="line">
              <a:avLst/>
            </a:prstGeom>
            <a:ln w="19050">
              <a:solidFill>
                <a:srgbClr val="00B05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flipV="1">
              <a:off x="5367342" y="2354395"/>
              <a:ext cx="3193676" cy="623890"/>
            </a:xfrm>
            <a:prstGeom prst="line">
              <a:avLst/>
            </a:prstGeom>
            <a:ln w="12700">
              <a:solidFill>
                <a:srgbClr val="FF000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5448827" y="2999488"/>
              <a:ext cx="3105890" cy="794689"/>
            </a:xfrm>
            <a:prstGeom prst="line">
              <a:avLst/>
            </a:prstGeom>
            <a:ln w="19050">
              <a:solidFill>
                <a:srgbClr val="00B05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 flipV="1">
              <a:off x="7077086" y="2635054"/>
              <a:ext cx="1458300" cy="343231"/>
            </a:xfrm>
            <a:prstGeom prst="line">
              <a:avLst/>
            </a:prstGeom>
            <a:ln w="381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7081395" y="3017844"/>
              <a:ext cx="1424139" cy="386102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6527953" y="6161952"/>
              <a:ext cx="752157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DCIS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278803" y="6161952"/>
              <a:ext cx="844081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CA1D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8588496" y="65314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1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8588498" y="1861391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2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588496" y="2149793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3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8588496" y="2457395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G4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8588496" y="3193112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5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588496" y="3559498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6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588496" y="3761205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7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8588496" y="5935512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8</a:t>
              </a: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3117178" y="65314"/>
              <a:ext cx="5918877" cy="6521603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9796DE6C-5ED5-3547-8CD6-21A9DC7B611F}"/>
              </a:ext>
            </a:extLst>
          </p:cNvPr>
          <p:cNvSpPr txBox="1"/>
          <p:nvPr/>
        </p:nvSpPr>
        <p:spPr>
          <a:xfrm>
            <a:off x="9485376" y="6490369"/>
            <a:ext cx="1851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</a:t>
            </a:r>
            <a:r>
              <a:rPr lang="en-US" b="1" dirty="0" smtClean="0"/>
              <a:t>S16.</a:t>
            </a:r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D5446C56-8E51-1A49-B0A8-08BDC9EAC7A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2206" y="116504"/>
            <a:ext cx="6598394" cy="200326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xmlns="" id="{9868989E-A047-6E45-8DD4-90CFC981758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2412" y="2164129"/>
            <a:ext cx="6588188" cy="20764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xmlns="" id="{864D18C0-6C34-E643-886B-C61683E1E65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2412" y="4281864"/>
            <a:ext cx="6588188" cy="2167208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12573483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7178" y="551935"/>
            <a:ext cx="9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roup 6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0" y="1703115"/>
            <a:ext cx="3590531" cy="3498026"/>
            <a:chOff x="3117178" y="65314"/>
            <a:chExt cx="6055851" cy="6589449"/>
          </a:xfrm>
        </p:grpSpPr>
        <p:cxnSp>
          <p:nvCxnSpPr>
            <p:cNvPr id="8" name="Straight Connector 7"/>
            <p:cNvCxnSpPr/>
            <p:nvPr/>
          </p:nvCxnSpPr>
          <p:spPr>
            <a:xfrm>
              <a:off x="3280257" y="2986523"/>
              <a:ext cx="5519351" cy="823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3117178" y="6125143"/>
              <a:ext cx="1030633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Normal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868027" y="6125143"/>
              <a:ext cx="973856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Benign</a:t>
              </a:r>
            </a:p>
          </p:txBody>
        </p:sp>
        <p:cxnSp>
          <p:nvCxnSpPr>
            <p:cNvPr id="11" name="Straight Connector 10"/>
            <p:cNvCxnSpPr/>
            <p:nvPr/>
          </p:nvCxnSpPr>
          <p:spPr>
            <a:xfrm>
              <a:off x="3722044" y="2883882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5367342" y="2878044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7032211" y="2878044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8561019" y="2886282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 flipV="1">
              <a:off x="3722044" y="143040"/>
              <a:ext cx="4838975" cy="2843483"/>
            </a:xfrm>
            <a:prstGeom prst="line">
              <a:avLst/>
            </a:prstGeom>
            <a:ln w="127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>
              <a:off x="3722044" y="2994761"/>
              <a:ext cx="4918103" cy="3166524"/>
            </a:xfrm>
            <a:prstGeom prst="line">
              <a:avLst/>
            </a:prstGeom>
            <a:ln w="19050">
              <a:solidFill>
                <a:srgbClr val="00B05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 flipV="1">
              <a:off x="3722044" y="2186444"/>
              <a:ext cx="1577744" cy="800079"/>
            </a:xfrm>
            <a:prstGeom prst="line">
              <a:avLst/>
            </a:prstGeom>
            <a:ln w="12700">
              <a:solidFill>
                <a:srgbClr val="FF000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V="1">
              <a:off x="5288215" y="2130461"/>
              <a:ext cx="3272803" cy="65314"/>
            </a:xfrm>
            <a:prstGeom prst="line">
              <a:avLst/>
            </a:prstGeom>
            <a:ln w="12700">
              <a:solidFill>
                <a:srgbClr val="FF000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>
              <a:off x="3797560" y="2978285"/>
              <a:ext cx="1496442" cy="824130"/>
            </a:xfrm>
            <a:prstGeom prst="line">
              <a:avLst/>
            </a:prstGeom>
            <a:ln w="19050">
              <a:solidFill>
                <a:srgbClr val="00B05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5288215" y="3802415"/>
              <a:ext cx="3288986" cy="110192"/>
            </a:xfrm>
            <a:prstGeom prst="line">
              <a:avLst/>
            </a:prstGeom>
            <a:ln w="19050">
              <a:solidFill>
                <a:srgbClr val="00B05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 flipV="1">
              <a:off x="5367342" y="2354395"/>
              <a:ext cx="3193676" cy="623890"/>
            </a:xfrm>
            <a:prstGeom prst="line">
              <a:avLst/>
            </a:prstGeom>
            <a:ln w="12700">
              <a:solidFill>
                <a:srgbClr val="FF000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5448827" y="2999488"/>
              <a:ext cx="3105890" cy="794689"/>
            </a:xfrm>
            <a:prstGeom prst="line">
              <a:avLst/>
            </a:prstGeom>
            <a:ln w="38100">
              <a:solidFill>
                <a:srgbClr val="00B05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flipV="1">
              <a:off x="7077086" y="2635054"/>
              <a:ext cx="1458300" cy="343231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7081395" y="3017844"/>
              <a:ext cx="1424139" cy="386102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24"/>
            <p:cNvSpPr txBox="1"/>
            <p:nvPr/>
          </p:nvSpPr>
          <p:spPr>
            <a:xfrm>
              <a:off x="6527953" y="6161952"/>
              <a:ext cx="752157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DCIS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8278803" y="6161952"/>
              <a:ext cx="844081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CA1D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588496" y="65314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1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8588498" y="1861391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2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8588496" y="2149793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3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588496" y="2457395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4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8588496" y="3193112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5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8588496" y="3559498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G6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588496" y="3807760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7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588496" y="5935512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8</a:t>
              </a:r>
            </a:p>
          </p:txBody>
        </p:sp>
        <p:sp>
          <p:nvSpPr>
            <p:cNvPr id="35" name="Rectangle 34"/>
            <p:cNvSpPr/>
            <p:nvPr/>
          </p:nvSpPr>
          <p:spPr>
            <a:xfrm>
              <a:off x="3117178" y="65314"/>
              <a:ext cx="5918877" cy="6521603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149467E9-347D-7D4E-BBF8-FAFFAD6CA9A9}"/>
              </a:ext>
            </a:extLst>
          </p:cNvPr>
          <p:cNvSpPr txBox="1"/>
          <p:nvPr/>
        </p:nvSpPr>
        <p:spPr>
          <a:xfrm>
            <a:off x="10289709" y="6020655"/>
            <a:ext cx="18386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</a:t>
            </a:r>
            <a:r>
              <a:rPr lang="en-US" b="1" dirty="0" smtClean="0"/>
              <a:t>S17.</a:t>
            </a:r>
            <a:endParaRPr lang="en-US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42BFCB4E-0946-304D-8D8A-2458E1FE39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7294" y="629978"/>
            <a:ext cx="8128587" cy="25662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xmlns="" id="{41F6BE4A-5DBC-DA49-90B7-EF3D958ED53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6060" y="3439875"/>
            <a:ext cx="8129821" cy="2521831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220015152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87178" y="551935"/>
            <a:ext cx="94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roup 8</a:t>
            </a:r>
          </a:p>
        </p:txBody>
      </p:sp>
      <p:grpSp>
        <p:nvGrpSpPr>
          <p:cNvPr id="8" name="Group 7"/>
          <p:cNvGrpSpPr/>
          <p:nvPr/>
        </p:nvGrpSpPr>
        <p:grpSpPr>
          <a:xfrm>
            <a:off x="228600" y="1756943"/>
            <a:ext cx="3590531" cy="3498026"/>
            <a:chOff x="3117178" y="65314"/>
            <a:chExt cx="6055851" cy="6589449"/>
          </a:xfrm>
        </p:grpSpPr>
        <p:cxnSp>
          <p:nvCxnSpPr>
            <p:cNvPr id="9" name="Straight Connector 8"/>
            <p:cNvCxnSpPr/>
            <p:nvPr/>
          </p:nvCxnSpPr>
          <p:spPr>
            <a:xfrm>
              <a:off x="3280257" y="2986523"/>
              <a:ext cx="5519351" cy="823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TextBox 9"/>
            <p:cNvSpPr txBox="1"/>
            <p:nvPr/>
          </p:nvSpPr>
          <p:spPr>
            <a:xfrm>
              <a:off x="3117178" y="6125143"/>
              <a:ext cx="1030633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Normal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868027" y="6125143"/>
              <a:ext cx="973856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Benign</a:t>
              </a:r>
            </a:p>
          </p:txBody>
        </p:sp>
        <p:cxnSp>
          <p:nvCxnSpPr>
            <p:cNvPr id="12" name="Straight Connector 11"/>
            <p:cNvCxnSpPr/>
            <p:nvPr/>
          </p:nvCxnSpPr>
          <p:spPr>
            <a:xfrm>
              <a:off x="3722044" y="2883882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>
              <a:off x="5367342" y="2878044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/>
          </p:nvCxnSpPr>
          <p:spPr>
            <a:xfrm>
              <a:off x="7032211" y="2878044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/>
          </p:nvCxnSpPr>
          <p:spPr>
            <a:xfrm>
              <a:off x="8561019" y="2886282"/>
              <a:ext cx="0" cy="216958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/>
          </p:nvCxnSpPr>
          <p:spPr>
            <a:xfrm flipV="1">
              <a:off x="3722044" y="143040"/>
              <a:ext cx="4838975" cy="2843483"/>
            </a:xfrm>
            <a:prstGeom prst="line">
              <a:avLst/>
            </a:prstGeom>
            <a:ln w="12700">
              <a:solidFill>
                <a:srgbClr val="FF000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>
            <a:xfrm>
              <a:off x="3722044" y="2994761"/>
              <a:ext cx="4918103" cy="3166524"/>
            </a:xfrm>
            <a:prstGeom prst="line">
              <a:avLst/>
            </a:prstGeom>
            <a:ln w="38100">
              <a:solidFill>
                <a:srgbClr val="00B050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V="1">
              <a:off x="3722044" y="2186444"/>
              <a:ext cx="1577744" cy="800079"/>
            </a:xfrm>
            <a:prstGeom prst="line">
              <a:avLst/>
            </a:prstGeom>
            <a:ln w="12700">
              <a:solidFill>
                <a:srgbClr val="FF000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/>
          </p:nvCxnSpPr>
          <p:spPr>
            <a:xfrm flipV="1">
              <a:off x="5288215" y="2130461"/>
              <a:ext cx="3272803" cy="65314"/>
            </a:xfrm>
            <a:prstGeom prst="line">
              <a:avLst/>
            </a:prstGeom>
            <a:ln w="12700">
              <a:solidFill>
                <a:srgbClr val="FF000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3797560" y="2978285"/>
              <a:ext cx="1496442" cy="824130"/>
            </a:xfrm>
            <a:prstGeom prst="line">
              <a:avLst/>
            </a:prstGeom>
            <a:ln w="12700">
              <a:solidFill>
                <a:srgbClr val="00B05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5288215" y="3802415"/>
              <a:ext cx="3288986" cy="110192"/>
            </a:xfrm>
            <a:prstGeom prst="line">
              <a:avLst/>
            </a:prstGeom>
            <a:ln w="12700">
              <a:solidFill>
                <a:srgbClr val="00B050"/>
              </a:solidFill>
              <a:prstDash val="dash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flipV="1">
              <a:off x="5367342" y="2354395"/>
              <a:ext cx="3193676" cy="623890"/>
            </a:xfrm>
            <a:prstGeom prst="line">
              <a:avLst/>
            </a:prstGeom>
            <a:ln w="12700">
              <a:solidFill>
                <a:srgbClr val="FF000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>
              <a:off x="5448827" y="2999488"/>
              <a:ext cx="3105890" cy="794689"/>
            </a:xfrm>
            <a:prstGeom prst="line">
              <a:avLst/>
            </a:prstGeom>
            <a:ln w="12700">
              <a:solidFill>
                <a:srgbClr val="00B050"/>
              </a:solidFill>
              <a:prstDash val="lgDashDot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 flipV="1">
              <a:off x="7077086" y="2635054"/>
              <a:ext cx="1458300" cy="343231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7081395" y="3017844"/>
              <a:ext cx="1424139" cy="386102"/>
            </a:xfrm>
            <a:prstGeom prst="line">
              <a:avLst/>
            </a:prstGeom>
            <a:ln w="1905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6527953" y="6161952"/>
              <a:ext cx="752157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DCIS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8278803" y="6161952"/>
              <a:ext cx="844081" cy="492811"/>
            </a:xfrm>
            <a:prstGeom prst="rect">
              <a:avLst/>
            </a:prstGeom>
            <a:noFill/>
          </p:spPr>
          <p:txBody>
            <a:bodyPr wrap="none" rtlCol="0" anchor="b" anchorCtr="0">
              <a:spAutoFit/>
            </a:bodyPr>
            <a:lstStyle/>
            <a:p>
              <a:r>
                <a:rPr lang="en-US" sz="1100" dirty="0"/>
                <a:t>CA1D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8588496" y="65314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1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8588498" y="1861391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2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8588496" y="2149793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3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8588496" y="2457395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4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8588496" y="3193112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5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588496" y="3559498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6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588496" y="3807760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G7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8588496" y="5935512"/>
              <a:ext cx="584531" cy="49281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/>
                <a:t>G8</a:t>
              </a:r>
            </a:p>
          </p:txBody>
        </p:sp>
        <p:sp>
          <p:nvSpPr>
            <p:cNvPr id="36" name="Rectangle 35"/>
            <p:cNvSpPr/>
            <p:nvPr/>
          </p:nvSpPr>
          <p:spPr>
            <a:xfrm>
              <a:off x="3117178" y="65314"/>
              <a:ext cx="5918877" cy="6521603"/>
            </a:xfrm>
            <a:prstGeom prst="rect">
              <a:avLst/>
            </a:prstGeom>
            <a:noFill/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983C51F4-FBCC-F842-9293-6848EB56AEA2}"/>
              </a:ext>
            </a:extLst>
          </p:cNvPr>
          <p:cNvSpPr txBox="1"/>
          <p:nvPr/>
        </p:nvSpPr>
        <p:spPr>
          <a:xfrm>
            <a:off x="9028175" y="6011334"/>
            <a:ext cx="18329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</a:t>
            </a:r>
            <a:r>
              <a:rPr lang="en-US" b="1" dirty="0" smtClean="0"/>
              <a:t>S18.</a:t>
            </a:r>
            <a:endParaRPr lang="en-US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7187CC23-949E-B545-8D82-205F77355C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6182" y="1016000"/>
            <a:ext cx="6475685" cy="24899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xmlns="" id="{B7ACEEF6-EDBF-BB40-9CF4-E6CE84780C8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26182" y="3625126"/>
            <a:ext cx="6475685" cy="2386208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2022358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7896983" y="6567270"/>
            <a:ext cx="17552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S2.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0444E71F-9A44-B249-8C82-80B291EDF41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6877" y="0"/>
            <a:ext cx="7189465" cy="63713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04808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xmlns="" id="{FD8CBF09-5AE1-B648-BE9F-A95FF4B15E5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82403787"/>
              </p:ext>
            </p:extLst>
          </p:nvPr>
        </p:nvGraphicFramePr>
        <p:xfrm>
          <a:off x="432658" y="349706"/>
          <a:ext cx="5784762" cy="33911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5">
            <a:extLst>
              <a:ext uri="{FF2B5EF4-FFF2-40B4-BE49-F238E27FC236}">
                <a16:creationId xmlns:a16="http://schemas.microsoft.com/office/drawing/2014/main" xmlns="" id="{C19217CB-DE07-E34C-A245-55BFC7EC7AA3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510679" y="1571360"/>
            <a:ext cx="188667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en-US" sz="1200" b="1" dirty="0"/>
              <a:t> miR-34a levels (fold)</a:t>
            </a:r>
          </a:p>
        </p:txBody>
      </p:sp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xmlns="" id="{53C94DB4-9D04-5A49-9D8D-CB1B95CBE0E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5903934"/>
              </p:ext>
            </p:extLst>
          </p:nvPr>
        </p:nvGraphicFramePr>
        <p:xfrm>
          <a:off x="6217420" y="3513835"/>
          <a:ext cx="5766117" cy="280126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TextBox 5">
            <a:extLst>
              <a:ext uri="{FF2B5EF4-FFF2-40B4-BE49-F238E27FC236}">
                <a16:creationId xmlns:a16="http://schemas.microsoft.com/office/drawing/2014/main" xmlns="" id="{7A426CBD-E0ED-054C-9943-6891E261C90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5305885" y="4591804"/>
            <a:ext cx="188667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altLang="en-US" sz="1200" b="1" dirty="0"/>
              <a:t> miR-210 levels (fold)</a:t>
            </a:r>
          </a:p>
        </p:txBody>
      </p:sp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xmlns="" id="{EE8104F3-950D-7E42-BF1D-11BDEE18BD5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3563293"/>
              </p:ext>
            </p:extLst>
          </p:nvPr>
        </p:nvGraphicFramePr>
        <p:xfrm>
          <a:off x="7204387" y="425703"/>
          <a:ext cx="460884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DE96E1D5-403B-9D4C-8065-69A7A8818106}"/>
              </a:ext>
            </a:extLst>
          </p:cNvPr>
          <p:cNvSpPr txBox="1"/>
          <p:nvPr/>
        </p:nvSpPr>
        <p:spPr>
          <a:xfrm rot="16200000">
            <a:off x="5757563" y="1025524"/>
            <a:ext cx="22007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miR-140-3p-1 levels(fold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8860FE2-6249-0549-9D70-B03A33C2AD5B}"/>
              </a:ext>
            </a:extLst>
          </p:cNvPr>
          <p:cNvSpPr txBox="1"/>
          <p:nvPr/>
        </p:nvSpPr>
        <p:spPr>
          <a:xfrm>
            <a:off x="10090828" y="1786009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xmlns="" id="{563AAC4B-AF45-8F4C-97CB-47675EFA0892}"/>
              </a:ext>
            </a:extLst>
          </p:cNvPr>
          <p:cNvCxnSpPr/>
          <p:nvPr/>
        </p:nvCxnSpPr>
        <p:spPr>
          <a:xfrm>
            <a:off x="9200938" y="2045274"/>
            <a:ext cx="2108289" cy="0"/>
          </a:xfrm>
          <a:prstGeom prst="line">
            <a:avLst/>
          </a:prstGeom>
          <a:ln w="9525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E5CBF9A2-B260-D144-9DEA-7C27320BC5AD}"/>
              </a:ext>
            </a:extLst>
          </p:cNvPr>
          <p:cNvSpPr txBox="1"/>
          <p:nvPr/>
        </p:nvSpPr>
        <p:spPr>
          <a:xfrm>
            <a:off x="10026392" y="407323"/>
            <a:ext cx="14654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miR-140-3p-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913529D9-E58C-C64B-9F3D-AF0FD88993A1}"/>
              </a:ext>
            </a:extLst>
          </p:cNvPr>
          <p:cNvSpPr txBox="1"/>
          <p:nvPr/>
        </p:nvSpPr>
        <p:spPr>
          <a:xfrm>
            <a:off x="0" y="4117"/>
            <a:ext cx="1852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u="sng" dirty="0"/>
              <a:t>miRNA validatio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373A2CFB-95C3-D84B-8E74-73C718EC2C33}"/>
              </a:ext>
            </a:extLst>
          </p:cNvPr>
          <p:cNvSpPr txBox="1"/>
          <p:nvPr/>
        </p:nvSpPr>
        <p:spPr>
          <a:xfrm>
            <a:off x="10358880" y="6488668"/>
            <a:ext cx="1833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S3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73463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xmlns="" id="{255A65C3-7382-0743-89E4-EE14A00D281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666" y="584200"/>
            <a:ext cx="5579533" cy="334772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0067F26E-CA63-5D47-B99C-F9A6D791DF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7532" y="584199"/>
            <a:ext cx="5404555" cy="3242733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63802402-01C2-CB43-8278-0AA53EDAC952}"/>
              </a:ext>
            </a:extLst>
          </p:cNvPr>
          <p:cNvSpPr/>
          <p:nvPr/>
        </p:nvSpPr>
        <p:spPr>
          <a:xfrm>
            <a:off x="10518018" y="6380239"/>
            <a:ext cx="17546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S4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83646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xmlns="" id="{4B714BEE-F3B2-004F-9DDA-59D3C8D9CE9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5917341"/>
              </p:ext>
            </p:extLst>
          </p:nvPr>
        </p:nvGraphicFramePr>
        <p:xfrm>
          <a:off x="621053" y="113102"/>
          <a:ext cx="4931602" cy="34380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6EEB66CF-ECD6-1543-9C9D-9A6085A1DEE4}"/>
              </a:ext>
            </a:extLst>
          </p:cNvPr>
          <p:cNvSpPr txBox="1"/>
          <p:nvPr/>
        </p:nvSpPr>
        <p:spPr>
          <a:xfrm>
            <a:off x="118351" y="7259"/>
            <a:ext cx="364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A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52F5DCC2-95A1-7C49-BEDB-C73B3B8E139F}"/>
              </a:ext>
            </a:extLst>
          </p:cNvPr>
          <p:cNvSpPr txBox="1"/>
          <p:nvPr/>
        </p:nvSpPr>
        <p:spPr>
          <a:xfrm>
            <a:off x="1104091" y="244326"/>
            <a:ext cx="12850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MCF10.AT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3EBA3C70-9E00-D74C-A13A-70C684001C63}"/>
              </a:ext>
            </a:extLst>
          </p:cNvPr>
          <p:cNvSpPr txBox="1"/>
          <p:nvPr/>
        </p:nvSpPr>
        <p:spPr>
          <a:xfrm rot="16200000">
            <a:off x="-316255" y="1471053"/>
            <a:ext cx="15976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DICER mRNA (fold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F443B493-C4A4-F647-ACCB-620B1A685EF8}"/>
              </a:ext>
            </a:extLst>
          </p:cNvPr>
          <p:cNvSpPr txBox="1"/>
          <p:nvPr/>
        </p:nvSpPr>
        <p:spPr>
          <a:xfrm>
            <a:off x="4271427" y="367437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xmlns="" id="{DA94E5D4-1DDF-834C-BF79-FD027BE4113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351901"/>
              </p:ext>
            </p:extLst>
          </p:nvPr>
        </p:nvGraphicFramePr>
        <p:xfrm>
          <a:off x="7044222" y="3222730"/>
          <a:ext cx="4267738" cy="28480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108F6FAB-66D9-5B47-8503-964D38576828}"/>
              </a:ext>
            </a:extLst>
          </p:cNvPr>
          <p:cNvSpPr txBox="1"/>
          <p:nvPr/>
        </p:nvSpPr>
        <p:spPr>
          <a:xfrm rot="16200000">
            <a:off x="5934942" y="4402638"/>
            <a:ext cx="20425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DICER protein level (fold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25232C34-C84D-8241-9E25-2555793BEDC4}"/>
              </a:ext>
            </a:extLst>
          </p:cNvPr>
          <p:cNvSpPr txBox="1"/>
          <p:nvPr/>
        </p:nvSpPr>
        <p:spPr>
          <a:xfrm>
            <a:off x="7516748" y="3318322"/>
            <a:ext cx="12850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MCF10.AT1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2E73418C-2879-9643-8373-ED0EE8D832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31806" y="2176275"/>
            <a:ext cx="2978670" cy="8274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xmlns="" id="{AAD0886D-3941-BB44-91E3-AAA9F1CCC61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31806" y="1094066"/>
            <a:ext cx="2978670" cy="9547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E5419CBC-0438-E741-9DA3-296B60EA7933}"/>
              </a:ext>
            </a:extLst>
          </p:cNvPr>
          <p:cNvSpPr txBox="1"/>
          <p:nvPr/>
        </p:nvSpPr>
        <p:spPr>
          <a:xfrm>
            <a:off x="7592638" y="384001"/>
            <a:ext cx="1159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cramble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mic (30nM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487A0DCF-E68A-1641-B9B3-5A992AA224F9}"/>
              </a:ext>
            </a:extLst>
          </p:cNvPr>
          <p:cNvSpPr txBox="1"/>
          <p:nvPr/>
        </p:nvSpPr>
        <p:spPr>
          <a:xfrm>
            <a:off x="8951791" y="402851"/>
            <a:ext cx="1159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R-29c-3p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imic (30nM)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xmlns="" id="{5632A428-CBBB-7940-B27D-6ABD38F263C7}"/>
              </a:ext>
            </a:extLst>
          </p:cNvPr>
          <p:cNvCxnSpPr/>
          <p:nvPr/>
        </p:nvCxnSpPr>
        <p:spPr>
          <a:xfrm>
            <a:off x="7627328" y="906626"/>
            <a:ext cx="11592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xmlns="" id="{40333FCA-65A2-B346-BC36-5015424910DB}"/>
              </a:ext>
            </a:extLst>
          </p:cNvPr>
          <p:cNvCxnSpPr/>
          <p:nvPr/>
        </p:nvCxnSpPr>
        <p:spPr>
          <a:xfrm>
            <a:off x="8951791" y="912312"/>
            <a:ext cx="115929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CF100714-A2A2-6741-8349-9358C5286CC0}"/>
              </a:ext>
            </a:extLst>
          </p:cNvPr>
          <p:cNvSpPr txBox="1"/>
          <p:nvPr/>
        </p:nvSpPr>
        <p:spPr>
          <a:xfrm>
            <a:off x="10410476" y="1407640"/>
            <a:ext cx="7441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ICER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149128F8-903B-1847-9826-7964BF1E6973}"/>
              </a:ext>
            </a:extLst>
          </p:cNvPr>
          <p:cNvSpPr txBox="1"/>
          <p:nvPr/>
        </p:nvSpPr>
        <p:spPr>
          <a:xfrm>
            <a:off x="8230248" y="72163"/>
            <a:ext cx="128509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/>
                <a:cs typeface="Arial"/>
              </a:rPr>
              <a:t>MCF10.AT1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821063A9-40C2-8749-B29D-0988DE5A221B}"/>
              </a:ext>
            </a:extLst>
          </p:cNvPr>
          <p:cNvSpPr txBox="1"/>
          <p:nvPr/>
        </p:nvSpPr>
        <p:spPr>
          <a:xfrm>
            <a:off x="10434860" y="2416785"/>
            <a:ext cx="8771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4CABC60A-19BC-5C4C-8B11-E0D59D2E9F6C}"/>
              </a:ext>
            </a:extLst>
          </p:cNvPr>
          <p:cNvSpPr txBox="1"/>
          <p:nvPr/>
        </p:nvSpPr>
        <p:spPr>
          <a:xfrm>
            <a:off x="6407890" y="1168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B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4D8043DD-01BE-B847-A56B-8324D74768CA}"/>
              </a:ext>
            </a:extLst>
          </p:cNvPr>
          <p:cNvSpPr txBox="1"/>
          <p:nvPr/>
        </p:nvSpPr>
        <p:spPr>
          <a:xfrm>
            <a:off x="6407890" y="291495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/>
                <a:cs typeface="Arial"/>
              </a:rPr>
              <a:t>C.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xmlns="" id="{75C2D545-09FE-3241-983D-8398B2A0D820}"/>
              </a:ext>
            </a:extLst>
          </p:cNvPr>
          <p:cNvSpPr/>
          <p:nvPr/>
        </p:nvSpPr>
        <p:spPr>
          <a:xfrm>
            <a:off x="10410476" y="6488668"/>
            <a:ext cx="17546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S5.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718851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924585FF-CF0F-944C-92A2-A5B95FD8E1B9}"/>
              </a:ext>
            </a:extLst>
          </p:cNvPr>
          <p:cNvSpPr/>
          <p:nvPr/>
        </p:nvSpPr>
        <p:spPr>
          <a:xfrm>
            <a:off x="8558729" y="6283477"/>
            <a:ext cx="17546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S6. </a:t>
            </a:r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70FF85AE-5063-8D42-9B79-3544632DE9DC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022839" y="529809"/>
            <a:ext cx="9290538" cy="47807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21160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xmlns="" id="{41491443-F47E-804C-886C-117090AE2F06}"/>
              </a:ext>
            </a:extLst>
          </p:cNvPr>
          <p:cNvSpPr/>
          <p:nvPr/>
        </p:nvSpPr>
        <p:spPr>
          <a:xfrm>
            <a:off x="9289142" y="6282267"/>
            <a:ext cx="175464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S7. </a:t>
            </a:r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6B829FD5-3E1C-4541-AF78-EC8B405BA56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38" t="5979" r="1181" b="5206"/>
          <a:stretch/>
        </p:blipFill>
        <p:spPr>
          <a:xfrm>
            <a:off x="1667933" y="1303867"/>
            <a:ext cx="8983135" cy="29210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5BD2CC8B-45D8-C440-B778-0B76BD5A5F1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98" r="74314" b="60585"/>
          <a:stretch/>
        </p:blipFill>
        <p:spPr>
          <a:xfrm>
            <a:off x="1645643" y="1470644"/>
            <a:ext cx="1109133" cy="4148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50742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50197233"/>
              </p:ext>
            </p:extLst>
          </p:nvPr>
        </p:nvGraphicFramePr>
        <p:xfrm>
          <a:off x="369333" y="1230859"/>
          <a:ext cx="3863483" cy="21317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4602140"/>
              </p:ext>
            </p:extLst>
          </p:nvPr>
        </p:nvGraphicFramePr>
        <p:xfrm>
          <a:off x="4107412" y="1154660"/>
          <a:ext cx="3863484" cy="22619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7270987"/>
              </p:ext>
            </p:extLst>
          </p:nvPr>
        </p:nvGraphicFramePr>
        <p:xfrm>
          <a:off x="369333" y="3314170"/>
          <a:ext cx="3863483" cy="22619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3170299"/>
              </p:ext>
            </p:extLst>
          </p:nvPr>
        </p:nvGraphicFramePr>
        <p:xfrm>
          <a:off x="4143057" y="3314170"/>
          <a:ext cx="3863483" cy="22619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3" name="TextBox 12"/>
          <p:cNvSpPr txBox="1"/>
          <p:nvPr/>
        </p:nvSpPr>
        <p:spPr>
          <a:xfrm rot="16200000">
            <a:off x="-1445364" y="3493982"/>
            <a:ext cx="3260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Relative mRNA expression (fold)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907278" y="1418465"/>
            <a:ext cx="817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/>
              <a:t>TIAM1</a:t>
            </a:r>
          </a:p>
        </p:txBody>
      </p:sp>
      <p:graphicFrame>
        <p:nvGraphicFramePr>
          <p:cNvPr id="15" name="グラフ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0602777"/>
              </p:ext>
            </p:extLst>
          </p:nvPr>
        </p:nvGraphicFramePr>
        <p:xfrm>
          <a:off x="8095258" y="1271437"/>
          <a:ext cx="3035300" cy="2146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6" name="グラフ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7196807"/>
              </p:ext>
            </p:extLst>
          </p:nvPr>
        </p:nvGraphicFramePr>
        <p:xfrm>
          <a:off x="8095258" y="3484973"/>
          <a:ext cx="3035300" cy="21463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7" name="Rectangle 16"/>
          <p:cNvSpPr/>
          <p:nvPr/>
        </p:nvSpPr>
        <p:spPr>
          <a:xfrm>
            <a:off x="184666" y="138919"/>
            <a:ext cx="189638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/>
              <a:t>Gene Validation</a:t>
            </a:r>
            <a:endParaRPr lang="en-US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C531CAD1-B4B0-6449-8BCA-0E66292980F7}"/>
              </a:ext>
            </a:extLst>
          </p:cNvPr>
          <p:cNvSpPr txBox="1"/>
          <p:nvPr/>
        </p:nvSpPr>
        <p:spPr>
          <a:xfrm>
            <a:off x="9256342" y="5749359"/>
            <a:ext cx="19742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</a:t>
            </a:r>
            <a:r>
              <a:rPr lang="en-US" b="1" dirty="0" smtClean="0"/>
              <a:t>S8.</a:t>
            </a:r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CD6038CD-3429-2544-979A-025DA8942193}"/>
              </a:ext>
            </a:extLst>
          </p:cNvPr>
          <p:cNvSpPr txBox="1"/>
          <p:nvPr/>
        </p:nvSpPr>
        <p:spPr>
          <a:xfrm>
            <a:off x="1919628" y="179617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8907A3C2-E0E6-814F-8314-8855772847B6}"/>
              </a:ext>
            </a:extLst>
          </p:cNvPr>
          <p:cNvSpPr txBox="1"/>
          <p:nvPr/>
        </p:nvSpPr>
        <p:spPr>
          <a:xfrm>
            <a:off x="5596921" y="203956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21D52CFD-980B-194D-95AA-45E5E3AB04ED}"/>
              </a:ext>
            </a:extLst>
          </p:cNvPr>
          <p:cNvSpPr txBox="1"/>
          <p:nvPr/>
        </p:nvSpPr>
        <p:spPr>
          <a:xfrm>
            <a:off x="1919628" y="422624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xmlns="" id="{B56705AD-C3DF-E647-9191-CB0C2ECC13C4}"/>
              </a:ext>
            </a:extLst>
          </p:cNvPr>
          <p:cNvSpPr txBox="1"/>
          <p:nvPr/>
        </p:nvSpPr>
        <p:spPr>
          <a:xfrm>
            <a:off x="9185614" y="428710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DB0CBEE9-CEBC-0A4A-9173-AAF5341FF806}"/>
              </a:ext>
            </a:extLst>
          </p:cNvPr>
          <p:cNvSpPr txBox="1"/>
          <p:nvPr/>
        </p:nvSpPr>
        <p:spPr>
          <a:xfrm>
            <a:off x="5633070" y="446484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030596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666648" y="599967"/>
          <a:ext cx="36449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/>
          </p:nvPr>
        </p:nvGraphicFramePr>
        <p:xfrm>
          <a:off x="5777047" y="599967"/>
          <a:ext cx="3657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40792136"/>
              </p:ext>
            </p:extLst>
          </p:nvPr>
        </p:nvGraphicFramePr>
        <p:xfrm>
          <a:off x="666648" y="3343167"/>
          <a:ext cx="3683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Box 9"/>
          <p:cNvSpPr txBox="1"/>
          <p:nvPr/>
        </p:nvSpPr>
        <p:spPr>
          <a:xfrm rot="16200000">
            <a:off x="-937751" y="4425000"/>
            <a:ext cx="2660521" cy="2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Relative mRNA expression (fold)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-803098" y="1649376"/>
            <a:ext cx="2660521" cy="2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Relative mRNA expression (fold)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4286037" y="1649376"/>
            <a:ext cx="2660521" cy="2789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Relative mRNA expression (fold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4BE8F998-4A9A-6742-B07F-60D3E81FA4A8}"/>
              </a:ext>
            </a:extLst>
          </p:cNvPr>
          <p:cNvSpPr txBox="1"/>
          <p:nvPr/>
        </p:nvSpPr>
        <p:spPr>
          <a:xfrm>
            <a:off x="7747000" y="5901701"/>
            <a:ext cx="18773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</a:t>
            </a:r>
            <a:r>
              <a:rPr lang="en-US" b="1" dirty="0" smtClean="0"/>
              <a:t>S9.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00C59720-912F-BF44-99BA-3CFA327C79BF}"/>
              </a:ext>
            </a:extLst>
          </p:cNvPr>
          <p:cNvSpPr txBox="1"/>
          <p:nvPr/>
        </p:nvSpPr>
        <p:spPr>
          <a:xfrm>
            <a:off x="2010982" y="173836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4D3F8FEF-71CA-594A-A20D-A3E7767D86D5}"/>
              </a:ext>
            </a:extLst>
          </p:cNvPr>
          <p:cNvSpPr txBox="1"/>
          <p:nvPr/>
        </p:nvSpPr>
        <p:spPr>
          <a:xfrm>
            <a:off x="2010982" y="524097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5AF6740B-71F2-9B4E-9E96-57E95E5F0368}"/>
              </a:ext>
            </a:extLst>
          </p:cNvPr>
          <p:cNvSpPr txBox="1"/>
          <p:nvPr/>
        </p:nvSpPr>
        <p:spPr>
          <a:xfrm>
            <a:off x="7130559" y="136903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*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xmlns="" id="{5C575856-6404-CF45-A955-D82E57D18C97}"/>
              </a:ext>
            </a:extLst>
          </p:cNvPr>
          <p:cNvSpPr/>
          <p:nvPr/>
        </p:nvSpPr>
        <p:spPr>
          <a:xfrm>
            <a:off x="184666" y="138919"/>
            <a:ext cx="189638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u="sng" dirty="0"/>
              <a:t>Gene Validation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0299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2440</TotalTime>
  <Words>306</Words>
  <Application>Microsoft Office PowerPoint</Application>
  <PresentationFormat>Widescreen</PresentationFormat>
  <Paragraphs>162</Paragraphs>
  <Slides>18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8</vt:i4>
      </vt:variant>
    </vt:vector>
  </HeadingPairs>
  <TitlesOfParts>
    <vt:vector size="24" baseType="lpstr">
      <vt:lpstr>ＭＳ Ｐゴシック</vt:lpstr>
      <vt:lpstr>Arial</vt:lpstr>
      <vt:lpstr>Calibri</vt:lpstr>
      <vt:lpstr>Calibri Light</vt:lpstr>
      <vt:lpstr>Mang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. D. Anderson Cancer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,Zhenlin</dc:creator>
  <cp:lastModifiedBy>Bhardwaj,Anjana</cp:lastModifiedBy>
  <cp:revision>245</cp:revision>
  <cp:lastPrinted>2019-07-16T17:11:12Z</cp:lastPrinted>
  <dcterms:created xsi:type="dcterms:W3CDTF">2018-08-31T13:35:03Z</dcterms:created>
  <dcterms:modified xsi:type="dcterms:W3CDTF">2020-03-18T02:52:49Z</dcterms:modified>
</cp:coreProperties>
</file>